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vertBarState="minimized">
    <p:restoredLeft sz="3972" autoAdjust="0"/>
    <p:restoredTop sz="97892" autoAdjust="0"/>
  </p:normalViewPr>
  <p:slideViewPr>
    <p:cSldViewPr>
      <p:cViewPr>
        <p:scale>
          <a:sx n="100" d="100"/>
          <a:sy n="100" d="100"/>
        </p:scale>
        <p:origin x="-1530" y="84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5838;&#39064;&#30456;&#20851;\201209&#25968;&#25454;&#34917;&#20805;\S0910-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5838;&#39064;&#30456;&#20851;\201209&#25968;&#25454;&#34917;&#20805;\s1214-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5838;&#39064;&#30456;&#20851;\201209&#25968;&#25454;&#34917;&#20805;\S06-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5838;&#39064;&#30456;&#20851;\201209&#25968;&#25454;&#34917;&#20805;\s08-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5838;&#39064;&#30456;&#20851;\201209&#25968;&#25454;&#34917;&#20805;\s03-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5838;&#39064;&#30456;&#20851;\201209&#25968;&#25454;&#34917;&#20805;\S05-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5838;&#39064;&#30456;&#20851;\201209&#25968;&#25454;&#34917;&#20805;\s02-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5838;&#39064;&#30456;&#20851;\201209&#25968;&#25454;&#34917;&#20805;\s04-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lineChart>
        <c:grouping val="standard"/>
        <c:ser>
          <c:idx val="0"/>
          <c:order val="0"/>
          <c:spPr>
            <a:ln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H$46:$H$55</c:f>
                <c:numCache>
                  <c:formatCode>General</c:formatCode>
                  <c:ptCount val="10"/>
                  <c:pt idx="0">
                    <c:v>1.5619978361728371E-2</c:v>
                  </c:pt>
                  <c:pt idx="1">
                    <c:v>3.5264923841377582E-2</c:v>
                  </c:pt>
                  <c:pt idx="2">
                    <c:v>3.5264923841377582E-2</c:v>
                  </c:pt>
                  <c:pt idx="3">
                    <c:v>5.7474282265412624E-2</c:v>
                  </c:pt>
                  <c:pt idx="4">
                    <c:v>2.5306689402620156E-2</c:v>
                  </c:pt>
                  <c:pt idx="5">
                    <c:v>7.7511521836503117E-2</c:v>
                  </c:pt>
                  <c:pt idx="6">
                    <c:v>1.9798606169368061E-2</c:v>
                  </c:pt>
                  <c:pt idx="7">
                    <c:v>1.3959479790029214E-2</c:v>
                  </c:pt>
                  <c:pt idx="8">
                    <c:v>0.17494568588694712</c:v>
                  </c:pt>
                  <c:pt idx="9">
                    <c:v>2.5306689402620156E-2</c:v>
                  </c:pt>
                </c:numCache>
              </c:numRef>
            </c:plus>
            <c:minus>
              <c:numRef>
                <c:f>Sheet1!$I$46:$I$55</c:f>
                <c:numCache>
                  <c:formatCode>General</c:formatCode>
                  <c:ptCount val="10"/>
                  <c:pt idx="0">
                    <c:v>1.5379747045666147E-2</c:v>
                  </c:pt>
                  <c:pt idx="1">
                    <c:v>3.4063671075154629E-2</c:v>
                  </c:pt>
                  <c:pt idx="2">
                    <c:v>3.4063671075154629E-2</c:v>
                  </c:pt>
                  <c:pt idx="3">
                    <c:v>5.4350524858427146E-2</c:v>
                  </c:pt>
                  <c:pt idx="4">
                    <c:v>2.4682067974573618E-2</c:v>
                  </c:pt>
                  <c:pt idx="5">
                    <c:v>7.1935677963232039E-2</c:v>
                  </c:pt>
                  <c:pt idx="6">
                    <c:v>1.9414231446870503E-2</c:v>
                  </c:pt>
                  <c:pt idx="7">
                    <c:v>1.3767295506640799E-2</c:v>
                  </c:pt>
                  <c:pt idx="8">
                    <c:v>0.14889682815838556</c:v>
                  </c:pt>
                  <c:pt idx="9">
                    <c:v>2.4682067974573618E-2</c:v>
                  </c:pt>
                </c:numCache>
              </c:numRef>
            </c:minus>
          </c:errBars>
          <c:cat>
            <c:numRef>
              <c:f>Sheet1!$F$46:$F$55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24</c:v>
                </c:pt>
                <c:pt idx="5">
                  <c:v>26</c:v>
                </c:pt>
                <c:pt idx="6">
                  <c:v>28</c:v>
                </c:pt>
                <c:pt idx="7">
                  <c:v>32</c:v>
                </c:pt>
                <c:pt idx="8">
                  <c:v>36</c:v>
                </c:pt>
                <c:pt idx="9">
                  <c:v>48</c:v>
                </c:pt>
              </c:numCache>
            </c:numRef>
          </c:cat>
          <c:val>
            <c:numRef>
              <c:f>Sheet1!$G$46:$G$55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spPr>
            <a:ln>
              <a:solidFill>
                <a:prstClr val="white">
                  <a:lumMod val="50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H$57:$H$66</c:f>
                <c:numCache>
                  <c:formatCode>General</c:formatCode>
                  <c:ptCount val="10"/>
                  <c:pt idx="0">
                    <c:v>3.9929674651242079E-2</c:v>
                  </c:pt>
                  <c:pt idx="1">
                    <c:v>6.9362946712245965E-2</c:v>
                  </c:pt>
                  <c:pt idx="2">
                    <c:v>0.1259212599629789</c:v>
                  </c:pt>
                  <c:pt idx="3">
                    <c:v>2.7080111948054476E-2</c:v>
                  </c:pt>
                  <c:pt idx="4">
                    <c:v>7.592181548032205E-2</c:v>
                  </c:pt>
                  <c:pt idx="5">
                    <c:v>0.13285815658451727</c:v>
                  </c:pt>
                  <c:pt idx="6">
                    <c:v>7.4072981160626813E-2</c:v>
                  </c:pt>
                  <c:pt idx="7">
                    <c:v>4.9872133572530543E-2</c:v>
                  </c:pt>
                  <c:pt idx="8">
                    <c:v>1.831965652888079E-2</c:v>
                  </c:pt>
                  <c:pt idx="9">
                    <c:v>4.3731155342207277E-2</c:v>
                  </c:pt>
                </c:numCache>
              </c:numRef>
            </c:plus>
            <c:minus>
              <c:numRef>
                <c:f>Sheet1!$I$57:$I$66</c:f>
                <c:numCache>
                  <c:formatCode>General</c:formatCode>
                  <c:ptCount val="10"/>
                  <c:pt idx="0">
                    <c:v>3.8772530874883415E-2</c:v>
                  </c:pt>
                  <c:pt idx="1">
                    <c:v>6.2764254015975782E-2</c:v>
                  </c:pt>
                  <c:pt idx="2">
                    <c:v>0.11416342521245272</c:v>
                  </c:pt>
                  <c:pt idx="3">
                    <c:v>2.6087922401223644E-2</c:v>
                  </c:pt>
                  <c:pt idx="4">
                    <c:v>6.9472981170508138E-2</c:v>
                  </c:pt>
                  <c:pt idx="5">
                    <c:v>0.12221919267659789</c:v>
                  </c:pt>
                  <c:pt idx="6">
                    <c:v>6.7477716896966966E-2</c:v>
                  </c:pt>
                  <c:pt idx="7">
                    <c:v>4.8173305618699355E-2</c:v>
                  </c:pt>
                  <c:pt idx="8">
                    <c:v>1.803790484550306E-2</c:v>
                  </c:pt>
                  <c:pt idx="9">
                    <c:v>4.1639443445777045E-2</c:v>
                  </c:pt>
                </c:numCache>
              </c:numRef>
            </c:minus>
          </c:errBars>
          <c:val>
            <c:numRef>
              <c:f>Sheet1!$G$57:$G$66</c:f>
              <c:numCache>
                <c:formatCode>General</c:formatCode>
                <c:ptCount val="10"/>
                <c:pt idx="0">
                  <c:v>1.33792755478611</c:v>
                </c:pt>
                <c:pt idx="1">
                  <c:v>0.65975395538644765</c:v>
                </c:pt>
                <c:pt idx="2">
                  <c:v>1.2226402776920606</c:v>
                </c:pt>
                <c:pt idx="3">
                  <c:v>0.71202509779854151</c:v>
                </c:pt>
                <c:pt idx="4">
                  <c:v>0.81790205855778175</c:v>
                </c:pt>
                <c:pt idx="5">
                  <c:v>1.5262592089605584</c:v>
                </c:pt>
                <c:pt idx="6">
                  <c:v>0.75785828325520421</c:v>
                </c:pt>
                <c:pt idx="7">
                  <c:v>1.414213562373096</c:v>
                </c:pt>
                <c:pt idx="8">
                  <c:v>1.1728349492318781</c:v>
                </c:pt>
                <c:pt idx="9">
                  <c:v>0.87055056329612235</c:v>
                </c:pt>
              </c:numCache>
            </c:numRef>
          </c:val>
        </c:ser>
        <c:ser>
          <c:idx val="2"/>
          <c:order val="2"/>
          <c:spPr>
            <a:ln>
              <a:solidFill>
                <a:prstClr val="black">
                  <a:lumMod val="95000"/>
                  <a:lumOff val="5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H$68:$H$77</c:f>
                <c:numCache>
                  <c:formatCode>General</c:formatCode>
                  <c:ptCount val="10"/>
                  <c:pt idx="0">
                    <c:v>5.4447064215308538E-2</c:v>
                  </c:pt>
                  <c:pt idx="1">
                    <c:v>6.651442852538092E-2</c:v>
                  </c:pt>
                  <c:pt idx="2">
                    <c:v>1.9855226075708002E-2</c:v>
                  </c:pt>
                  <c:pt idx="3">
                    <c:v>2.679834045132146E-2</c:v>
                  </c:pt>
                  <c:pt idx="4">
                    <c:v>5.945569051020913E-2</c:v>
                  </c:pt>
                  <c:pt idx="5">
                    <c:v>0.14295426208004144</c:v>
                  </c:pt>
                  <c:pt idx="6">
                    <c:v>6.8167153999812324E-2</c:v>
                  </c:pt>
                  <c:pt idx="7">
                    <c:v>4.3891329580579286E-2</c:v>
                  </c:pt>
                  <c:pt idx="8">
                    <c:v>5.4107542406253817E-2</c:v>
                  </c:pt>
                  <c:pt idx="9">
                    <c:v>4.1313462898720482E-2</c:v>
                  </c:pt>
                </c:numCache>
              </c:numRef>
            </c:plus>
            <c:minus>
              <c:numRef>
                <c:f>Sheet1!$I$68:$I$77</c:f>
                <c:numCache>
                  <c:formatCode>General</c:formatCode>
                  <c:ptCount val="10"/>
                  <c:pt idx="0">
                    <c:v>5.0981927925416386E-2</c:v>
                  </c:pt>
                  <c:pt idx="1">
                    <c:v>6.1349359874915743E-2</c:v>
                  </c:pt>
                  <c:pt idx="2">
                    <c:v>1.9365158036057047E-2</c:v>
                  </c:pt>
                  <c:pt idx="3">
                    <c:v>2.5634955953625645E-2</c:v>
                  </c:pt>
                  <c:pt idx="4">
                    <c:v>5.4694620797066412E-2</c:v>
                  </c:pt>
                  <c:pt idx="5">
                    <c:v>0.1298304865139582</c:v>
                  </c:pt>
                  <c:pt idx="6">
                    <c:v>6.4247339532472303E-2</c:v>
                  </c:pt>
                  <c:pt idx="7">
                    <c:v>4.2008766379686723E-2</c:v>
                  </c:pt>
                  <c:pt idx="8">
                    <c:v>5.1256224624123367E-2</c:v>
                  </c:pt>
                  <c:pt idx="9">
                    <c:v>3.8016138363951291E-2</c:v>
                  </c:pt>
                </c:numCache>
              </c:numRef>
            </c:minus>
          </c:errBars>
          <c:val>
            <c:numRef>
              <c:f>Sheet1!$G$68:$G$77</c:f>
              <c:numCache>
                <c:formatCode>General</c:formatCode>
                <c:ptCount val="10"/>
                <c:pt idx="0">
                  <c:v>0.80106987758962611</c:v>
                </c:pt>
                <c:pt idx="1">
                  <c:v>0.79004131186338311</c:v>
                </c:pt>
                <c:pt idx="2">
                  <c:v>0.78458409789674632</c:v>
                </c:pt>
                <c:pt idx="3">
                  <c:v>0.59049633071475938</c:v>
                </c:pt>
                <c:pt idx="4">
                  <c:v>0.68302012837719983</c:v>
                </c:pt>
                <c:pt idx="5">
                  <c:v>1.4142135623730951</c:v>
                </c:pt>
                <c:pt idx="6">
                  <c:v>1.1172871380722302</c:v>
                </c:pt>
                <c:pt idx="7">
                  <c:v>0.97942029758692661</c:v>
                </c:pt>
                <c:pt idx="8">
                  <c:v>0.97265494741228664</c:v>
                </c:pt>
                <c:pt idx="9">
                  <c:v>0.47631899902197267</c:v>
                </c:pt>
              </c:numCache>
            </c:numRef>
          </c:val>
        </c:ser>
        <c:marker val="1"/>
        <c:axId val="51884032"/>
        <c:axId val="51885568"/>
      </c:lineChart>
      <c:catAx>
        <c:axId val="51884032"/>
        <c:scaling>
          <c:orientation val="minMax"/>
        </c:scaling>
        <c:axPos val="b"/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51885568"/>
        <c:crosses val="autoZero"/>
        <c:auto val="1"/>
        <c:lblAlgn val="ctr"/>
        <c:lblOffset val="100"/>
      </c:catAx>
      <c:valAx>
        <c:axId val="51885568"/>
        <c:scaling>
          <c:orientation val="minMax"/>
        </c:scaling>
        <c:axPos val="l"/>
        <c:majorGridlines>
          <c:spPr>
            <a:ln w="12700">
              <a:solidFill>
                <a:srgbClr val="000000"/>
              </a:solidFill>
              <a:prstDash val="sysDot"/>
            </a:ln>
          </c:spPr>
        </c:majorGridlines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51884032"/>
        <c:crosses val="autoZero"/>
        <c:crossBetween val="between"/>
      </c:valAx>
      <c:spPr>
        <a:ln w="19050">
          <a:solidFill>
            <a:srgbClr val="000000"/>
          </a:solidFill>
        </a:ln>
      </c:spPr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lineChart>
        <c:grouping val="standard"/>
        <c:ser>
          <c:idx val="0"/>
          <c:order val="0"/>
          <c:spPr>
            <a:ln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H$50:$H$59</c:f>
                <c:numCache>
                  <c:formatCode>General</c:formatCode>
                  <c:ptCount val="10"/>
                  <c:pt idx="0">
                    <c:v>7.2144050961157946E-2</c:v>
                  </c:pt>
                  <c:pt idx="1">
                    <c:v>2.1012125707193411E-2</c:v>
                  </c:pt>
                  <c:pt idx="2">
                    <c:v>0.11360820571912655</c:v>
                  </c:pt>
                  <c:pt idx="3">
                    <c:v>0.15820947236336694</c:v>
                  </c:pt>
                  <c:pt idx="4">
                    <c:v>7.3245698279671201E-2</c:v>
                  </c:pt>
                  <c:pt idx="5">
                    <c:v>7.7511521836503103E-2</c:v>
                  </c:pt>
                  <c:pt idx="6">
                    <c:v>9.5454425236114068E-2</c:v>
                  </c:pt>
                  <c:pt idx="7">
                    <c:v>8.7982424072171689E-2</c:v>
                  </c:pt>
                  <c:pt idx="8">
                    <c:v>7.5049481914640725E-2</c:v>
                  </c:pt>
                  <c:pt idx="9">
                    <c:v>5.8823494418713484E-2</c:v>
                  </c:pt>
                </c:numCache>
              </c:numRef>
            </c:plus>
            <c:minus>
              <c:numRef>
                <c:f>Sheet1!$I$50:$I$59</c:f>
                <c:numCache>
                  <c:formatCode>General</c:formatCode>
                  <c:ptCount val="10"/>
                  <c:pt idx="0">
                    <c:v>6.728951291245068E-2</c:v>
                  </c:pt>
                  <c:pt idx="1">
                    <c:v>2.0579702413073699E-2</c:v>
                  </c:pt>
                  <c:pt idx="2">
                    <c:v>0.10201811115944653</c:v>
                  </c:pt>
                  <c:pt idx="3">
                    <c:v>0.13659832365257171</c:v>
                  </c:pt>
                  <c:pt idx="4">
                    <c:v>6.8246905994664875E-2</c:v>
                  </c:pt>
                  <c:pt idx="5">
                    <c:v>7.1935677963231914E-2</c:v>
                  </c:pt>
                  <c:pt idx="6">
                    <c:v>8.7136829280268224E-2</c:v>
                  </c:pt>
                  <c:pt idx="7">
                    <c:v>8.0867504957355285E-2</c:v>
                  </c:pt>
                  <c:pt idx="8">
                    <c:v>6.9810258204095504E-2</c:v>
                  </c:pt>
                  <c:pt idx="9">
                    <c:v>5.5555524342616534E-2</c:v>
                  </c:pt>
                </c:numCache>
              </c:numRef>
            </c:minus>
          </c:errBars>
          <c:cat>
            <c:numRef>
              <c:f>Sheet1!$F$50:$F$59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24</c:v>
                </c:pt>
                <c:pt idx="5">
                  <c:v>26</c:v>
                </c:pt>
                <c:pt idx="6">
                  <c:v>28</c:v>
                </c:pt>
                <c:pt idx="7">
                  <c:v>32</c:v>
                </c:pt>
                <c:pt idx="8">
                  <c:v>36</c:v>
                </c:pt>
                <c:pt idx="9">
                  <c:v>48</c:v>
                </c:pt>
              </c:numCache>
            </c:numRef>
          </c:cat>
          <c:val>
            <c:numRef>
              <c:f>Sheet1!$G$50:$G$59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spPr>
            <a:ln>
              <a:solidFill>
                <a:prstClr val="white">
                  <a:lumMod val="50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H$61:$H$70</c:f>
                <c:numCache>
                  <c:formatCode>General</c:formatCode>
                  <c:ptCount val="10"/>
                  <c:pt idx="0">
                    <c:v>8.1594420163173045E-2</c:v>
                  </c:pt>
                  <c:pt idx="1">
                    <c:v>6.0410535674950361E-2</c:v>
                  </c:pt>
                  <c:pt idx="2">
                    <c:v>8.8424734150739245E-2</c:v>
                  </c:pt>
                  <c:pt idx="3">
                    <c:v>7.6580802383195298E-2</c:v>
                  </c:pt>
                  <c:pt idx="4">
                    <c:v>4.1229224599977757E-2</c:v>
                  </c:pt>
                  <c:pt idx="5">
                    <c:v>4.8201456847454797E-2</c:v>
                  </c:pt>
                  <c:pt idx="6">
                    <c:v>0.11623296620486534</c:v>
                  </c:pt>
                  <c:pt idx="7">
                    <c:v>0.18045622859001251</c:v>
                  </c:pt>
                  <c:pt idx="8">
                    <c:v>7.3217140669114777E-2</c:v>
                  </c:pt>
                  <c:pt idx="9">
                    <c:v>4.7854727839833078E-2</c:v>
                  </c:pt>
                </c:numCache>
              </c:numRef>
            </c:plus>
            <c:minus>
              <c:numRef>
                <c:f>Sheet1!$I$61:$I$70</c:f>
                <c:numCache>
                  <c:formatCode>General</c:formatCode>
                  <c:ptCount val="10"/>
                  <c:pt idx="0">
                    <c:v>7.7398884064280513E-2</c:v>
                  </c:pt>
                  <c:pt idx="1">
                    <c:v>5.6119366420514696E-2</c:v>
                  </c:pt>
                  <c:pt idx="2">
                    <c:v>8.0168118768163668E-2</c:v>
                  </c:pt>
                  <c:pt idx="3">
                    <c:v>7.0428156339801928E-2</c:v>
                  </c:pt>
                  <c:pt idx="4">
                    <c:v>3.8027636911630525E-2</c:v>
                  </c:pt>
                  <c:pt idx="5">
                    <c:v>4.5429729456605839E-2</c:v>
                  </c:pt>
                  <c:pt idx="6">
                    <c:v>0.10588388727947784</c:v>
                  </c:pt>
                  <c:pt idx="7">
                    <c:v>0.16230172736385762</c:v>
                  </c:pt>
                  <c:pt idx="8">
                    <c:v>6.782080099495412E-2</c:v>
                  </c:pt>
                  <c:pt idx="9">
                    <c:v>4.5565780686716732E-2</c:v>
                  </c:pt>
                </c:numCache>
              </c:numRef>
            </c:minus>
          </c:errBars>
          <c:val>
            <c:numRef>
              <c:f>Sheet1!$G$61:$G$70</c:f>
              <c:numCache>
                <c:formatCode>General</c:formatCode>
                <c:ptCount val="10"/>
                <c:pt idx="0">
                  <c:v>1.5052467474110638</c:v>
                </c:pt>
                <c:pt idx="1">
                  <c:v>0.79004131186338122</c:v>
                </c:pt>
                <c:pt idx="2">
                  <c:v>0.85856543643775562</c:v>
                </c:pt>
                <c:pt idx="3">
                  <c:v>0.87660572131603565</c:v>
                </c:pt>
                <c:pt idx="4">
                  <c:v>0.48971014879346408</c:v>
                </c:pt>
                <c:pt idx="5">
                  <c:v>0.79004131186338189</c:v>
                </c:pt>
                <c:pt idx="6">
                  <c:v>1.1892071150027221</c:v>
                </c:pt>
                <c:pt idx="7">
                  <c:v>1.6132835184442529</c:v>
                </c:pt>
                <c:pt idx="8">
                  <c:v>0.92018765062488028</c:v>
                </c:pt>
                <c:pt idx="9">
                  <c:v>0.95263799804393712</c:v>
                </c:pt>
              </c:numCache>
            </c:numRef>
          </c:val>
        </c:ser>
        <c:ser>
          <c:idx val="2"/>
          <c:order val="2"/>
          <c:spPr>
            <a:ln>
              <a:solidFill>
                <a:prstClr val="black">
                  <a:lumMod val="95000"/>
                  <a:lumOff val="5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H$72:$H$81</c:f>
                <c:numCache>
                  <c:formatCode>General</c:formatCode>
                  <c:ptCount val="10"/>
                  <c:pt idx="0">
                    <c:v>6.3575482089079705E-2</c:v>
                  </c:pt>
                  <c:pt idx="1">
                    <c:v>7.8374724407650143E-2</c:v>
                  </c:pt>
                  <c:pt idx="2">
                    <c:v>5.9292191146509729E-2</c:v>
                  </c:pt>
                  <c:pt idx="3">
                    <c:v>2.0217851213698571E-2</c:v>
                  </c:pt>
                  <c:pt idx="4">
                    <c:v>4.1905804089866307E-2</c:v>
                  </c:pt>
                  <c:pt idx="5">
                    <c:v>0.122601548538668</c:v>
                  </c:pt>
                  <c:pt idx="6">
                    <c:v>0.12759063375473478</c:v>
                  </c:pt>
                  <c:pt idx="7">
                    <c:v>0.11972455989991072</c:v>
                  </c:pt>
                  <c:pt idx="8">
                    <c:v>0.11316755276323662</c:v>
                  </c:pt>
                  <c:pt idx="9">
                    <c:v>9.5573588742317944E-2</c:v>
                  </c:pt>
                </c:numCache>
              </c:numRef>
            </c:plus>
            <c:minus>
              <c:numRef>
                <c:f>Sheet1!$I$72:$I$81</c:f>
                <c:numCache>
                  <c:formatCode>General</c:formatCode>
                  <c:ptCount val="10"/>
                  <c:pt idx="0">
                    <c:v>6.030646896813744E-2</c:v>
                  </c:pt>
                  <c:pt idx="1">
                    <c:v>7.2530362834737933E-2</c:v>
                  </c:pt>
                  <c:pt idx="2">
                    <c:v>5.5152987973084724E-2</c:v>
                  </c:pt>
                  <c:pt idx="3">
                    <c:v>1.964821996537958E-2</c:v>
                  </c:pt>
                  <c:pt idx="4">
                    <c:v>3.9386667519196512E-2</c:v>
                  </c:pt>
                  <c:pt idx="5">
                    <c:v>0.11230997703224405</c:v>
                  </c:pt>
                  <c:pt idx="6">
                    <c:v>0.11904627070425804</c:v>
                  </c:pt>
                  <c:pt idx="7">
                    <c:v>0.10976510544393632</c:v>
                  </c:pt>
                  <c:pt idx="8">
                    <c:v>0.10472870845891881</c:v>
                  </c:pt>
                  <c:pt idx="9">
                    <c:v>8.7945636086581513E-2</c:v>
                  </c:pt>
                </c:numCache>
              </c:numRef>
            </c:minus>
          </c:errBars>
          <c:val>
            <c:numRef>
              <c:f>Sheet1!$G$72:$G$81</c:f>
              <c:numCache>
                <c:formatCode>General</c:formatCode>
                <c:ptCount val="10"/>
                <c:pt idx="0">
                  <c:v>1.1728349492318801</c:v>
                </c:pt>
                <c:pt idx="1">
                  <c:v>0.97265494741228564</c:v>
                </c:pt>
                <c:pt idx="2">
                  <c:v>0.79004131186338045</c:v>
                </c:pt>
                <c:pt idx="3">
                  <c:v>0.69737183317520823</c:v>
                </c:pt>
                <c:pt idx="4">
                  <c:v>0.655196701929186</c:v>
                </c:pt>
                <c:pt idx="5">
                  <c:v>1.337927554786114</c:v>
                </c:pt>
                <c:pt idx="6">
                  <c:v>1.7776853623331437</c:v>
                </c:pt>
                <c:pt idx="7">
                  <c:v>1.3195079107728953</c:v>
                </c:pt>
                <c:pt idx="8">
                  <c:v>1.4044448757379902</c:v>
                </c:pt>
                <c:pt idx="9">
                  <c:v>1.1019051158766111</c:v>
                </c:pt>
              </c:numCache>
            </c:numRef>
          </c:val>
        </c:ser>
        <c:marker val="1"/>
        <c:axId val="73665536"/>
        <c:axId val="73671424"/>
      </c:lineChart>
      <c:catAx>
        <c:axId val="73665536"/>
        <c:scaling>
          <c:orientation val="minMax"/>
        </c:scaling>
        <c:axPos val="b"/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73671424"/>
        <c:crosses val="autoZero"/>
        <c:auto val="1"/>
        <c:lblAlgn val="ctr"/>
        <c:lblOffset val="100"/>
      </c:catAx>
      <c:valAx>
        <c:axId val="73671424"/>
        <c:scaling>
          <c:orientation val="minMax"/>
        </c:scaling>
        <c:axPos val="l"/>
        <c:majorGridlines>
          <c:spPr>
            <a:ln w="12700">
              <a:solidFill>
                <a:srgbClr val="000000"/>
              </a:solidFill>
              <a:prstDash val="sysDot"/>
            </a:ln>
          </c:spPr>
        </c:majorGridlines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73665536"/>
        <c:crosses val="autoZero"/>
        <c:crossBetween val="between"/>
      </c:valAx>
      <c:spPr>
        <a:ln w="19050">
          <a:solidFill>
            <a:srgbClr val="000000"/>
          </a:solidFill>
        </a:ln>
      </c:spPr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lineChart>
        <c:grouping val="standard"/>
        <c:ser>
          <c:idx val="0"/>
          <c:order val="0"/>
          <c:spPr>
            <a:ln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K$50:$K$59</c:f>
                <c:numCache>
                  <c:formatCode>General</c:formatCode>
                  <c:ptCount val="10"/>
                  <c:pt idx="0">
                    <c:v>6.3959119401055795E-2</c:v>
                  </c:pt>
                  <c:pt idx="1">
                    <c:v>3.5264923841377582E-2</c:v>
                  </c:pt>
                  <c:pt idx="2">
                    <c:v>0.10619229456948302</c:v>
                  </c:pt>
                  <c:pt idx="3">
                    <c:v>9.4293701260739438E-2</c:v>
                  </c:pt>
                  <c:pt idx="4">
                    <c:v>7.5049481914640725E-2</c:v>
                  </c:pt>
                  <c:pt idx="5">
                    <c:v>9.2825069561747756E-2</c:v>
                  </c:pt>
                  <c:pt idx="6">
                    <c:v>7.3245698279671201E-2</c:v>
                  </c:pt>
                  <c:pt idx="7">
                    <c:v>3.8032524459856276E-2</c:v>
                  </c:pt>
                  <c:pt idx="8">
                    <c:v>0.12868467566801403</c:v>
                  </c:pt>
                  <c:pt idx="9">
                    <c:v>9.7739884615977379E-2</c:v>
                  </c:pt>
                </c:numCache>
              </c:numRef>
            </c:plus>
            <c:minus>
              <c:numRef>
                <c:f>Sheet1!$L$50:$L$59</c:f>
                <c:numCache>
                  <c:formatCode>General</c:formatCode>
                  <c:ptCount val="10"/>
                  <c:pt idx="0">
                    <c:v>6.0114264011442119E-2</c:v>
                  </c:pt>
                  <c:pt idx="1">
                    <c:v>3.4063671075154602E-2</c:v>
                  </c:pt>
                  <c:pt idx="2">
                    <c:v>9.599804219465527E-2</c:v>
                  </c:pt>
                  <c:pt idx="3">
                    <c:v>8.6168549770599748E-2</c:v>
                  </c:pt>
                  <c:pt idx="4">
                    <c:v>6.9810258204095504E-2</c:v>
                  </c:pt>
                  <c:pt idx="5">
                    <c:v>8.4940464990405348E-2</c:v>
                  </c:pt>
                  <c:pt idx="6">
                    <c:v>6.8246905994664875E-2</c:v>
                  </c:pt>
                  <c:pt idx="7">
                    <c:v>3.6639048935048241E-2</c:v>
                  </c:pt>
                  <c:pt idx="8">
                    <c:v>0.11401295547124669</c:v>
                  </c:pt>
                  <c:pt idx="9">
                    <c:v>8.9037381246441505E-2</c:v>
                  </c:pt>
                </c:numCache>
              </c:numRef>
            </c:minus>
          </c:errBars>
          <c:cat>
            <c:numRef>
              <c:f>Sheet1!$I$50:$I$59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24</c:v>
                </c:pt>
                <c:pt idx="5">
                  <c:v>26</c:v>
                </c:pt>
                <c:pt idx="6">
                  <c:v>28</c:v>
                </c:pt>
                <c:pt idx="7">
                  <c:v>32</c:v>
                </c:pt>
                <c:pt idx="8">
                  <c:v>36</c:v>
                </c:pt>
                <c:pt idx="9">
                  <c:v>48</c:v>
                </c:pt>
              </c:numCache>
            </c:numRef>
          </c:cat>
          <c:val>
            <c:numRef>
              <c:f>Sheet1!$J$50:$J$59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spPr>
            <a:ln>
              <a:solidFill>
                <a:prstClr val="white">
                  <a:lumMod val="50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K$61:$K$70</c:f>
                <c:numCache>
                  <c:formatCode>General</c:formatCode>
                  <c:ptCount val="10"/>
                  <c:pt idx="0">
                    <c:v>2.3917024960539587E-2</c:v>
                  </c:pt>
                  <c:pt idx="1">
                    <c:v>8.4777935066234766E-2</c:v>
                  </c:pt>
                  <c:pt idx="2">
                    <c:v>0.12226782562733463</c:v>
                  </c:pt>
                  <c:pt idx="3">
                    <c:v>6.1011311843640552E-2</c:v>
                  </c:pt>
                  <c:pt idx="4">
                    <c:v>6.1891776147636524E-2</c:v>
                  </c:pt>
                  <c:pt idx="5">
                    <c:v>2.892152570652463E-2</c:v>
                  </c:pt>
                  <c:pt idx="6">
                    <c:v>6.027865503465657E-2</c:v>
                  </c:pt>
                  <c:pt idx="7">
                    <c:v>4.5685852318544357E-2</c:v>
                  </c:pt>
                  <c:pt idx="8">
                    <c:v>3.0597047710690852E-2</c:v>
                  </c:pt>
                  <c:pt idx="9">
                    <c:v>3.3934294805383736E-2</c:v>
                  </c:pt>
                </c:numCache>
              </c:numRef>
            </c:plus>
            <c:minus>
              <c:numRef>
                <c:f>Sheet1!$L$61:$L$70</c:f>
                <c:numCache>
                  <c:formatCode>General</c:formatCode>
                  <c:ptCount val="10"/>
                  <c:pt idx="0">
                    <c:v>2.3398485740959787E-2</c:v>
                  </c:pt>
                  <c:pt idx="1">
                    <c:v>7.4262768285757841E-2</c:v>
                  </c:pt>
                  <c:pt idx="2">
                    <c:v>0.109432769304314</c:v>
                  </c:pt>
                  <c:pt idx="3">
                    <c:v>5.7502979621984592E-2</c:v>
                  </c:pt>
                  <c:pt idx="4">
                    <c:v>5.5240850423338567E-2</c:v>
                  </c:pt>
                  <c:pt idx="5">
                    <c:v>2.7665968306699852E-2</c:v>
                  </c:pt>
                  <c:pt idx="6">
                    <c:v>5.5264291064665474E-2</c:v>
                  </c:pt>
                  <c:pt idx="7">
                    <c:v>4.3437659543287599E-2</c:v>
                  </c:pt>
                  <c:pt idx="8">
                    <c:v>3.012647285655623E-2</c:v>
                  </c:pt>
                  <c:pt idx="9">
                    <c:v>3.1618384177805436E-2</c:v>
                  </c:pt>
                </c:numCache>
              </c:numRef>
            </c:minus>
          </c:errBars>
          <c:val>
            <c:numRef>
              <c:f>Sheet1!$J$61:$J$70</c:f>
              <c:numCache>
                <c:formatCode>General</c:formatCode>
                <c:ptCount val="10"/>
                <c:pt idx="0">
                  <c:v>1.0792282365044177</c:v>
                </c:pt>
                <c:pt idx="1">
                  <c:v>0.59873935230946462</c:v>
                </c:pt>
                <c:pt idx="2">
                  <c:v>1.0424657608411221</c:v>
                </c:pt>
                <c:pt idx="3">
                  <c:v>1</c:v>
                </c:pt>
                <c:pt idx="4">
                  <c:v>0.51405691332803394</c:v>
                </c:pt>
                <c:pt idx="5">
                  <c:v>0.63728031365963422</c:v>
                </c:pt>
                <c:pt idx="6">
                  <c:v>0.66434290704825583</c:v>
                </c:pt>
                <c:pt idx="7">
                  <c:v>0.88270299629065352</c:v>
                </c:pt>
                <c:pt idx="8">
                  <c:v>1.9588405951738541</c:v>
                </c:pt>
                <c:pt idx="9">
                  <c:v>0.46329403094518529</c:v>
                </c:pt>
              </c:numCache>
            </c:numRef>
          </c:val>
        </c:ser>
        <c:ser>
          <c:idx val="2"/>
          <c:order val="2"/>
          <c:spPr>
            <a:ln>
              <a:solidFill>
                <a:prstClr val="black">
                  <a:lumMod val="95000"/>
                  <a:lumOff val="5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K$72:$K$81</c:f>
                <c:numCache>
                  <c:formatCode>General</c:formatCode>
                  <c:ptCount val="10"/>
                  <c:pt idx="0">
                    <c:v>0.10096395017212623</c:v>
                  </c:pt>
                  <c:pt idx="1">
                    <c:v>5.8783425152090875E-2</c:v>
                  </c:pt>
                  <c:pt idx="2">
                    <c:v>8.3934693504268812E-2</c:v>
                  </c:pt>
                  <c:pt idx="3">
                    <c:v>9.0202866104356766E-3</c:v>
                  </c:pt>
                  <c:pt idx="4">
                    <c:v>8.7567071530623264E-2</c:v>
                  </c:pt>
                  <c:pt idx="5">
                    <c:v>6.1867667798202894E-2</c:v>
                  </c:pt>
                  <c:pt idx="6">
                    <c:v>0.14429884550588204</c:v>
                  </c:pt>
                  <c:pt idx="7">
                    <c:v>0.13198306931708848</c:v>
                  </c:pt>
                  <c:pt idx="8">
                    <c:v>0.23705675000755289</c:v>
                  </c:pt>
                  <c:pt idx="9">
                    <c:v>7.2322772089313994E-2</c:v>
                  </c:pt>
                </c:numCache>
              </c:numRef>
            </c:plus>
            <c:minus>
              <c:numRef>
                <c:f>Sheet1!$L$72:$L$81</c:f>
                <c:numCache>
                  <c:formatCode>General</c:formatCode>
                  <c:ptCount val="10"/>
                  <c:pt idx="0">
                    <c:v>8.9452751816950449E-2</c:v>
                  </c:pt>
                  <c:pt idx="1">
                    <c:v>5.2751218897587493E-2</c:v>
                  </c:pt>
                  <c:pt idx="2">
                    <c:v>7.2293235704464387E-2</c:v>
                  </c:pt>
                  <c:pt idx="3">
                    <c:v>8.8961016591150768E-3</c:v>
                  </c:pt>
                  <c:pt idx="4">
                    <c:v>8.1037241514964234E-2</c:v>
                  </c:pt>
                  <c:pt idx="5">
                    <c:v>5.828652523426181E-2</c:v>
                  </c:pt>
                  <c:pt idx="6">
                    <c:v>0.12485500258416952</c:v>
                  </c:pt>
                  <c:pt idx="7">
                    <c:v>0.12127543190779012</c:v>
                  </c:pt>
                  <c:pt idx="8">
                    <c:v>0.21345101365068042</c:v>
                  </c:pt>
                  <c:pt idx="9">
                    <c:v>6.5569669371185468E-2</c:v>
                  </c:pt>
                </c:numCache>
              </c:numRef>
            </c:minus>
          </c:errBars>
          <c:val>
            <c:numRef>
              <c:f>Sheet1!$J$72:$J$81</c:f>
              <c:numCache>
                <c:formatCode>General</c:formatCode>
                <c:ptCount val="10"/>
                <c:pt idx="0">
                  <c:v>0.78458409789674588</c:v>
                </c:pt>
                <c:pt idx="1">
                  <c:v>0.51405691332803394</c:v>
                </c:pt>
                <c:pt idx="2">
                  <c:v>0.52123288042056048</c:v>
                </c:pt>
                <c:pt idx="3">
                  <c:v>0.64617641531875125</c:v>
                </c:pt>
                <c:pt idx="4">
                  <c:v>1.0867348625260609</c:v>
                </c:pt>
                <c:pt idx="5">
                  <c:v>1.0069555500567284</c:v>
                </c:pt>
                <c:pt idx="6">
                  <c:v>0.92658806189037057</c:v>
                </c:pt>
                <c:pt idx="7">
                  <c:v>1.4948492486349279</c:v>
                </c:pt>
                <c:pt idx="8">
                  <c:v>2.1435469250725845</c:v>
                </c:pt>
                <c:pt idx="9">
                  <c:v>0.70222243786899785</c:v>
                </c:pt>
              </c:numCache>
            </c:numRef>
          </c:val>
        </c:ser>
        <c:marker val="1"/>
        <c:axId val="82620416"/>
        <c:axId val="82621952"/>
      </c:lineChart>
      <c:catAx>
        <c:axId val="82620416"/>
        <c:scaling>
          <c:orientation val="minMax"/>
        </c:scaling>
        <c:axPos val="b"/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621952"/>
        <c:crosses val="autoZero"/>
        <c:auto val="1"/>
        <c:lblAlgn val="ctr"/>
        <c:lblOffset val="100"/>
      </c:catAx>
      <c:valAx>
        <c:axId val="82621952"/>
        <c:scaling>
          <c:orientation val="minMax"/>
        </c:scaling>
        <c:axPos val="l"/>
        <c:majorGridlines>
          <c:spPr>
            <a:ln w="12700">
              <a:solidFill>
                <a:srgbClr val="000000"/>
              </a:solidFill>
              <a:prstDash val="sysDot"/>
            </a:ln>
          </c:spPr>
        </c:majorGridlines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620416"/>
        <c:crosses val="autoZero"/>
        <c:crossBetween val="between"/>
      </c:valAx>
      <c:spPr>
        <a:ln w="19050">
          <a:solidFill>
            <a:srgbClr val="000000"/>
          </a:solidFill>
        </a:ln>
      </c:spPr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lineChart>
        <c:grouping val="standard"/>
        <c:ser>
          <c:idx val="0"/>
          <c:order val="0"/>
          <c:spPr>
            <a:ln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I$51:$I$60</c:f>
                <c:numCache>
                  <c:formatCode>General</c:formatCode>
                  <c:ptCount val="10"/>
                  <c:pt idx="0">
                    <c:v>2.2161229804370082E-2</c:v>
                  </c:pt>
                  <c:pt idx="1">
                    <c:v>2.2161229804370082E-2</c:v>
                  </c:pt>
                  <c:pt idx="2">
                    <c:v>3.9989197144985951E-2</c:v>
                  </c:pt>
                  <c:pt idx="3">
                    <c:v>8.8291892602290312E-2</c:v>
                  </c:pt>
                  <c:pt idx="4">
                    <c:v>0.11825185765274958</c:v>
                  </c:pt>
                  <c:pt idx="5">
                    <c:v>2.8991493851486139E-2</c:v>
                  </c:pt>
                  <c:pt idx="6">
                    <c:v>3.8032524459856276E-2</c:v>
                  </c:pt>
                  <c:pt idx="7">
                    <c:v>5.175676587768252E-2</c:v>
                  </c:pt>
                  <c:pt idx="8">
                    <c:v>0.12039868454826352</c:v>
                  </c:pt>
                  <c:pt idx="9">
                    <c:v>3.8032524459856276E-2</c:v>
                  </c:pt>
                </c:numCache>
              </c:numRef>
            </c:plus>
            <c:minus>
              <c:numRef>
                <c:f>Sheet1!$J$51:$J$60</c:f>
                <c:numCache>
                  <c:formatCode>General</c:formatCode>
                  <c:ptCount val="10"/>
                  <c:pt idx="0">
                    <c:v>2.1680757553885602E-2</c:v>
                  </c:pt>
                  <c:pt idx="1">
                    <c:v>2.1680757553885602E-2</c:v>
                  </c:pt>
                  <c:pt idx="2">
                    <c:v>3.8451550511068411E-2</c:v>
                  </c:pt>
                  <c:pt idx="3">
                    <c:v>8.1128871034009564E-2</c:v>
                  </c:pt>
                  <c:pt idx="4">
                    <c:v>0.10574707016446583</c:v>
                  </c:pt>
                  <c:pt idx="5">
                    <c:v>2.817466813352543E-2</c:v>
                  </c:pt>
                  <c:pt idx="6">
                    <c:v>3.6639048935048241E-2</c:v>
                  </c:pt>
                  <c:pt idx="7">
                    <c:v>4.9209824511556088E-2</c:v>
                  </c:pt>
                  <c:pt idx="8">
                    <c:v>0.10746057292704472</c:v>
                  </c:pt>
                  <c:pt idx="9">
                    <c:v>3.6639048935048241E-2</c:v>
                  </c:pt>
                </c:numCache>
              </c:numRef>
            </c:minus>
          </c:errBars>
          <c:cat>
            <c:numRef>
              <c:f>Sheet1!$G$51:$G$60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24</c:v>
                </c:pt>
                <c:pt idx="5">
                  <c:v>26</c:v>
                </c:pt>
                <c:pt idx="6">
                  <c:v>28</c:v>
                </c:pt>
                <c:pt idx="7">
                  <c:v>32</c:v>
                </c:pt>
                <c:pt idx="8">
                  <c:v>36</c:v>
                </c:pt>
                <c:pt idx="9">
                  <c:v>48</c:v>
                </c:pt>
              </c:numCache>
            </c:numRef>
          </c:cat>
          <c:val>
            <c:numRef>
              <c:f>Sheet1!$H$51:$H$60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spPr>
            <a:ln>
              <a:solidFill>
                <a:prstClr val="white">
                  <a:lumMod val="50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I$62:$I$71</c:f>
                <c:numCache>
                  <c:formatCode>General</c:formatCode>
                  <c:ptCount val="10"/>
                  <c:pt idx="0">
                    <c:v>2.2993436811480372E-2</c:v>
                  </c:pt>
                  <c:pt idx="1">
                    <c:v>5.1213610859389934E-2</c:v>
                  </c:pt>
                  <c:pt idx="2">
                    <c:v>4.6731999883339113E-2</c:v>
                  </c:pt>
                  <c:pt idx="3">
                    <c:v>3.5975722823498951E-2</c:v>
                  </c:pt>
                  <c:pt idx="4">
                    <c:v>4.1636307013496424E-2</c:v>
                  </c:pt>
                  <c:pt idx="5">
                    <c:v>2.9108055398616939E-2</c:v>
                  </c:pt>
                  <c:pt idx="6">
                    <c:v>8.0657847037538768E-2</c:v>
                  </c:pt>
                  <c:pt idx="7">
                    <c:v>3.3114459646286183E-2</c:v>
                  </c:pt>
                  <c:pt idx="8">
                    <c:v>4.7782455054547437E-2</c:v>
                  </c:pt>
                  <c:pt idx="9">
                    <c:v>3.9154704234568877E-2</c:v>
                  </c:pt>
                </c:numCache>
              </c:numRef>
            </c:plus>
            <c:minus>
              <c:numRef>
                <c:f>Sheet1!$J$62:$J$71</c:f>
                <c:numCache>
                  <c:formatCode>General</c:formatCode>
                  <c:ptCount val="10"/>
                  <c:pt idx="0">
                    <c:v>2.2520238724446556E-2</c:v>
                  </c:pt>
                  <c:pt idx="1">
                    <c:v>4.7971829805893783E-2</c:v>
                  </c:pt>
                  <c:pt idx="2">
                    <c:v>4.3370301789153465E-2</c:v>
                  </c:pt>
                  <c:pt idx="3">
                    <c:v>3.4726414944791333E-2</c:v>
                  </c:pt>
                  <c:pt idx="4">
                    <c:v>3.8729665670219092E-2</c:v>
                  </c:pt>
                  <c:pt idx="5">
                    <c:v>2.7537898391174185E-2</c:v>
                  </c:pt>
                  <c:pt idx="6">
                    <c:v>7.419895926140907E-2</c:v>
                  </c:pt>
                  <c:pt idx="7">
                    <c:v>3.2154817695234886E-2</c:v>
                  </c:pt>
                  <c:pt idx="8">
                    <c:v>4.5809707649428433E-2</c:v>
                  </c:pt>
                  <c:pt idx="9">
                    <c:v>3.6888276827441092E-2</c:v>
                  </c:pt>
                </c:numCache>
              </c:numRef>
            </c:minus>
          </c:errBars>
          <c:val>
            <c:numRef>
              <c:f>Sheet1!$H$62:$H$71</c:f>
              <c:numCache>
                <c:formatCode>General</c:formatCode>
                <c:ptCount val="10"/>
                <c:pt idx="0">
                  <c:v>1.0942937012607401</c:v>
                </c:pt>
                <c:pt idx="1">
                  <c:v>0.75785828325520344</c:v>
                </c:pt>
                <c:pt idx="2">
                  <c:v>0.60290391384538544</c:v>
                </c:pt>
                <c:pt idx="3">
                  <c:v>1</c:v>
                </c:pt>
                <c:pt idx="4">
                  <c:v>0.55478473603392275</c:v>
                </c:pt>
                <c:pt idx="5">
                  <c:v>0.51050606285359668</c:v>
                </c:pt>
                <c:pt idx="6">
                  <c:v>0.92658806189037157</c:v>
                </c:pt>
                <c:pt idx="7">
                  <c:v>1.1095694720678366</c:v>
                </c:pt>
                <c:pt idx="8">
                  <c:v>1.109569472067836</c:v>
                </c:pt>
                <c:pt idx="9">
                  <c:v>0.63728031365963544</c:v>
                </c:pt>
              </c:numCache>
            </c:numRef>
          </c:val>
        </c:ser>
        <c:ser>
          <c:idx val="2"/>
          <c:order val="2"/>
          <c:spPr>
            <a:ln>
              <a:solidFill>
                <a:prstClr val="black">
                  <a:lumMod val="95000"/>
                  <a:lumOff val="5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I$74:$I$83</c:f>
                <c:numCache>
                  <c:formatCode>General</c:formatCode>
                  <c:ptCount val="10"/>
                  <c:pt idx="0">
                    <c:v>3.0130447929797952E-2</c:v>
                  </c:pt>
                  <c:pt idx="1">
                    <c:v>5.4745638519554052E-2</c:v>
                  </c:pt>
                  <c:pt idx="2">
                    <c:v>4.3123387060808871E-2</c:v>
                  </c:pt>
                  <c:pt idx="3">
                    <c:v>4.6127582154827054E-2</c:v>
                  </c:pt>
                  <c:pt idx="4">
                    <c:v>0.1134929703900327</c:v>
                  </c:pt>
                  <c:pt idx="5">
                    <c:v>6.4297472963037033E-2</c:v>
                  </c:pt>
                  <c:pt idx="6">
                    <c:v>6.9712552945424527E-2</c:v>
                  </c:pt>
                  <c:pt idx="7">
                    <c:v>0.12309047542341126</c:v>
                  </c:pt>
                  <c:pt idx="8">
                    <c:v>8.4102207072519683E-2</c:v>
                  </c:pt>
                  <c:pt idx="9">
                    <c:v>7.6523629191731113E-2</c:v>
                  </c:pt>
                </c:numCache>
              </c:numRef>
            </c:plus>
            <c:minus>
              <c:numRef>
                <c:f>Sheet1!$J$74:$J$83</c:f>
                <c:numCache>
                  <c:formatCode>General</c:formatCode>
                  <c:ptCount val="10"/>
                  <c:pt idx="0">
                    <c:v>2.951037227783029E-2</c:v>
                  </c:pt>
                  <c:pt idx="1">
                    <c:v>5.1009418073891907E-2</c:v>
                  </c:pt>
                  <c:pt idx="2">
                    <c:v>4.0906008387631483E-2</c:v>
                  </c:pt>
                  <c:pt idx="3">
                    <c:v>4.4827952835812923E-2</c:v>
                  </c:pt>
                  <c:pt idx="4">
                    <c:v>0.10087739609503356</c:v>
                  </c:pt>
                  <c:pt idx="5">
                    <c:v>5.8587705855945811E-2</c:v>
                  </c:pt>
                  <c:pt idx="6">
                    <c:v>6.5952093786781324E-2</c:v>
                  </c:pt>
                  <c:pt idx="7">
                    <c:v>0.11285102259127044</c:v>
                  </c:pt>
                  <c:pt idx="8">
                    <c:v>8.0451115165992765E-2</c:v>
                  </c:pt>
                  <c:pt idx="9">
                    <c:v>7.009998763789442E-2</c:v>
                  </c:pt>
                </c:numCache>
              </c:numRef>
            </c:minus>
          </c:errBars>
          <c:val>
            <c:numRef>
              <c:f>Sheet1!$H$74:$H$83</c:f>
              <c:numCache>
                <c:formatCode>General</c:formatCode>
                <c:ptCount val="10"/>
                <c:pt idx="0">
                  <c:v>1.4339552480158198</c:v>
                </c:pt>
                <c:pt idx="1">
                  <c:v>0.74742462431746892</c:v>
                </c:pt>
                <c:pt idx="2">
                  <c:v>0.79553648375491315</c:v>
                </c:pt>
                <c:pt idx="3">
                  <c:v>1.5910729675098363</c:v>
                </c:pt>
                <c:pt idx="4">
                  <c:v>0.90751915531715732</c:v>
                </c:pt>
                <c:pt idx="5">
                  <c:v>0.65975395538644765</c:v>
                </c:pt>
                <c:pt idx="6">
                  <c:v>1.2226402776920613</c:v>
                </c:pt>
                <c:pt idx="7">
                  <c:v>1.3566043274476698</c:v>
                </c:pt>
                <c:pt idx="8">
                  <c:v>1.8531761237807527</c:v>
                </c:pt>
                <c:pt idx="9">
                  <c:v>0.83508791942836968</c:v>
                </c:pt>
              </c:numCache>
            </c:numRef>
          </c:val>
        </c:ser>
        <c:marker val="1"/>
        <c:axId val="82516992"/>
        <c:axId val="82535168"/>
      </c:lineChart>
      <c:catAx>
        <c:axId val="82516992"/>
        <c:scaling>
          <c:orientation val="minMax"/>
        </c:scaling>
        <c:axPos val="b"/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535168"/>
        <c:crosses val="autoZero"/>
        <c:auto val="1"/>
        <c:lblAlgn val="ctr"/>
        <c:lblOffset val="100"/>
      </c:catAx>
      <c:valAx>
        <c:axId val="82535168"/>
        <c:scaling>
          <c:orientation val="minMax"/>
        </c:scaling>
        <c:axPos val="l"/>
        <c:majorGridlines>
          <c:spPr>
            <a:ln w="12700">
              <a:solidFill>
                <a:srgbClr val="000000"/>
              </a:solidFill>
              <a:prstDash val="sysDot"/>
            </a:ln>
          </c:spPr>
        </c:majorGridlines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516992"/>
        <c:crosses val="autoZero"/>
        <c:crossBetween val="between"/>
      </c:valAx>
      <c:spPr>
        <a:ln w="19050">
          <a:solidFill>
            <a:srgbClr val="000000"/>
          </a:solidFill>
        </a:ln>
      </c:spPr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lineChart>
        <c:grouping val="standard"/>
        <c:ser>
          <c:idx val="0"/>
          <c:order val="0"/>
          <c:spPr>
            <a:ln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S$39:$S$48</c:f>
                <c:numCache>
                  <c:formatCode>General</c:formatCode>
                  <c:ptCount val="10"/>
                  <c:pt idx="0">
                    <c:v>7.7511521836503103E-2</c:v>
                  </c:pt>
                  <c:pt idx="1">
                    <c:v>8.6734862526059719E-2</c:v>
                  </c:pt>
                  <c:pt idx="2">
                    <c:v>3.148394044747805E-2</c:v>
                  </c:pt>
                  <c:pt idx="3">
                    <c:v>6.9555500567188844E-3</c:v>
                  </c:pt>
                  <c:pt idx="4">
                    <c:v>7.5049481914640725E-2</c:v>
                  </c:pt>
                  <c:pt idx="5">
                    <c:v>9.2825069561747756E-2</c:v>
                  </c:pt>
                  <c:pt idx="6">
                    <c:v>1.3959479790029211E-2</c:v>
                  </c:pt>
                  <c:pt idx="7">
                    <c:v>9.4293701260739438E-2</c:v>
                  </c:pt>
                  <c:pt idx="8">
                    <c:v>7.6465033875845523E-2</c:v>
                  </c:pt>
                  <c:pt idx="9">
                    <c:v>9.7739884615977379E-2</c:v>
                  </c:pt>
                </c:numCache>
              </c:numRef>
            </c:plus>
            <c:minus>
              <c:numRef>
                <c:f>Sheet1!$T$39:$T$48</c:f>
                <c:numCache>
                  <c:formatCode>General</c:formatCode>
                  <c:ptCount val="10"/>
                  <c:pt idx="0">
                    <c:v>7.1935677963231914E-2</c:v>
                  </c:pt>
                  <c:pt idx="1">
                    <c:v>7.9812349375124839E-2</c:v>
                  </c:pt>
                  <c:pt idx="2">
                    <c:v>3.0522957472143938E-2</c:v>
                  </c:pt>
                  <c:pt idx="3">
                    <c:v>6.9075045629641884E-3</c:v>
                  </c:pt>
                  <c:pt idx="4">
                    <c:v>6.9810258204095504E-2</c:v>
                  </c:pt>
                  <c:pt idx="5">
                    <c:v>8.4940464990405348E-2</c:v>
                  </c:pt>
                  <c:pt idx="6">
                    <c:v>1.3767295506640799E-2</c:v>
                  </c:pt>
                  <c:pt idx="7">
                    <c:v>8.6168549770599748E-2</c:v>
                  </c:pt>
                  <c:pt idx="8">
                    <c:v>7.1033458096200763E-2</c:v>
                  </c:pt>
                  <c:pt idx="9">
                    <c:v>8.9037381246441505E-2</c:v>
                  </c:pt>
                </c:numCache>
              </c:numRef>
            </c:minus>
          </c:errBars>
          <c:cat>
            <c:numRef>
              <c:f>Sheet1!$Q$39:$Q$48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24</c:v>
                </c:pt>
                <c:pt idx="5">
                  <c:v>26</c:v>
                </c:pt>
                <c:pt idx="6">
                  <c:v>28</c:v>
                </c:pt>
                <c:pt idx="7">
                  <c:v>32</c:v>
                </c:pt>
                <c:pt idx="8">
                  <c:v>36</c:v>
                </c:pt>
                <c:pt idx="9">
                  <c:v>48</c:v>
                </c:pt>
              </c:numCache>
            </c:numRef>
          </c:cat>
          <c:val>
            <c:numRef>
              <c:f>Sheet1!$R$39:$R$48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spPr>
            <a:ln>
              <a:solidFill>
                <a:schemeClr val="bg1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S$51:$S$60</c:f>
                <c:numCache>
                  <c:formatCode>General</c:formatCode>
                  <c:ptCount val="10"/>
                  <c:pt idx="0">
                    <c:v>2.2224969412617892E-2</c:v>
                  </c:pt>
                  <c:pt idx="1">
                    <c:v>8.7364782601227334E-2</c:v>
                  </c:pt>
                  <c:pt idx="2">
                    <c:v>0.11507225920248809</c:v>
                  </c:pt>
                  <c:pt idx="3">
                    <c:v>4.2957693830143036E-2</c:v>
                  </c:pt>
                  <c:pt idx="4">
                    <c:v>0.10054348698132202</c:v>
                  </c:pt>
                  <c:pt idx="5">
                    <c:v>3.7764316453226275E-2</c:v>
                  </c:pt>
                  <c:pt idx="6">
                    <c:v>4.2676756158270622E-2</c:v>
                  </c:pt>
                  <c:pt idx="7">
                    <c:v>6.32203255747361E-2</c:v>
                  </c:pt>
                  <c:pt idx="8">
                    <c:v>5.2481716159890994E-2</c:v>
                  </c:pt>
                  <c:pt idx="9">
                    <c:v>7.9048825785904955E-2</c:v>
                  </c:pt>
                </c:numCache>
              </c:numRef>
            </c:plus>
            <c:minus>
              <c:numRef>
                <c:f>Sheet1!$T$51:$T$60</c:f>
                <c:numCache>
                  <c:formatCode>General</c:formatCode>
                  <c:ptCount val="10"/>
                  <c:pt idx="0">
                    <c:v>2.0586917405912258E-2</c:v>
                  </c:pt>
                  <c:pt idx="1">
                    <c:v>7.861128178292183E-2</c:v>
                  </c:pt>
                  <c:pt idx="2">
                    <c:v>0.10096536360968178</c:v>
                  </c:pt>
                  <c:pt idx="3">
                    <c:v>4.0622920623766413E-2</c:v>
                  </c:pt>
                  <c:pt idx="4">
                    <c:v>8.9739026266226748E-2</c:v>
                  </c:pt>
                  <c:pt idx="5">
                    <c:v>3.64528971299653E-2</c:v>
                  </c:pt>
                  <c:pt idx="6">
                    <c:v>3.9818821467438086E-2</c:v>
                  </c:pt>
                  <c:pt idx="7">
                    <c:v>5.8506019474032001E-2</c:v>
                  </c:pt>
                  <c:pt idx="8">
                    <c:v>4.8279105658550453E-2</c:v>
                  </c:pt>
                  <c:pt idx="9">
                    <c:v>7.365398800350588E-2</c:v>
                  </c:pt>
                </c:numCache>
              </c:numRef>
            </c:minus>
          </c:errBars>
          <c:val>
            <c:numRef>
              <c:f>Sheet1!$R$51:$R$60</c:f>
              <c:numCache>
                <c:formatCode>General</c:formatCode>
                <c:ptCount val="10"/>
                <c:pt idx="0">
                  <c:v>0.279321784518057</c:v>
                </c:pt>
                <c:pt idx="1">
                  <c:v>0.78458409789674588</c:v>
                </c:pt>
                <c:pt idx="2">
                  <c:v>0.82359101726758055</c:v>
                </c:pt>
                <c:pt idx="3">
                  <c:v>0.74742462431746925</c:v>
                </c:pt>
                <c:pt idx="4">
                  <c:v>0.83508791942837501</c:v>
                </c:pt>
                <c:pt idx="5">
                  <c:v>1.0497166836230658</c:v>
                </c:pt>
                <c:pt idx="6">
                  <c:v>0.59460355750136129</c:v>
                </c:pt>
                <c:pt idx="7">
                  <c:v>0.78458409789674588</c:v>
                </c:pt>
                <c:pt idx="8">
                  <c:v>0.60290391384538367</c:v>
                </c:pt>
                <c:pt idx="9">
                  <c:v>1.0792282365044206</c:v>
                </c:pt>
              </c:numCache>
            </c:numRef>
          </c:val>
        </c:ser>
        <c:ser>
          <c:idx val="2"/>
          <c:order val="2"/>
          <c:spPr>
            <a:ln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S$62:$S$71</c:f>
                <c:numCache>
                  <c:formatCode>General</c:formatCode>
                  <c:ptCount val="10"/>
                  <c:pt idx="0">
                    <c:v>6.0416565273177292E-2</c:v>
                  </c:pt>
                  <c:pt idx="1">
                    <c:v>9.4179262381767548E-2</c:v>
                  </c:pt>
                  <c:pt idx="2">
                    <c:v>1.701011023253602E-2</c:v>
                  </c:pt>
                  <c:pt idx="3">
                    <c:v>3.1414235295922591E-2</c:v>
                  </c:pt>
                  <c:pt idx="4">
                    <c:v>0.13362828109464631</c:v>
                  </c:pt>
                  <c:pt idx="5">
                    <c:v>5.9888221891564029E-2</c:v>
                  </c:pt>
                  <c:pt idx="6">
                    <c:v>5.5931744509642334E-2</c:v>
                  </c:pt>
                  <c:pt idx="7">
                    <c:v>0.12157410575996352</c:v>
                  </c:pt>
                  <c:pt idx="8">
                    <c:v>4.7658846451203767E-2</c:v>
                  </c:pt>
                  <c:pt idx="9">
                    <c:v>7.5704993574822424E-2</c:v>
                  </c:pt>
                </c:numCache>
              </c:numRef>
            </c:plus>
            <c:minus>
              <c:numRef>
                <c:f>Sheet1!$T$62:$T$70</c:f>
                <c:numCache>
                  <c:formatCode>General</c:formatCode>
                  <c:ptCount val="9"/>
                  <c:pt idx="0">
                    <c:v>5.4062640339522475E-2</c:v>
                  </c:pt>
                  <c:pt idx="1">
                    <c:v>8.451482492998838E-2</c:v>
                  </c:pt>
                  <c:pt idx="2">
                    <c:v>1.6065104639441701E-2</c:v>
                  </c:pt>
                  <c:pt idx="3">
                    <c:v>2.9719677517744878E-2</c:v>
                  </c:pt>
                  <c:pt idx="4">
                    <c:v>0.12054440450401582</c:v>
                  </c:pt>
                  <c:pt idx="5">
                    <c:v>5.6180787768328293E-2</c:v>
                  </c:pt>
                  <c:pt idx="6">
                    <c:v>5.1588456796926585E-2</c:v>
                  </c:pt>
                  <c:pt idx="7">
                    <c:v>0.10496728671359212</c:v>
                  </c:pt>
                  <c:pt idx="8">
                    <c:v>4.4406277637634751E-2</c:v>
                  </c:pt>
                </c:numCache>
              </c:numRef>
            </c:minus>
          </c:errBars>
          <c:val>
            <c:numRef>
              <c:f>Sheet1!$R$62:$R$71</c:f>
              <c:numCache>
                <c:formatCode>General</c:formatCode>
                <c:ptCount val="10"/>
                <c:pt idx="0">
                  <c:v>0.5140569133280336</c:v>
                </c:pt>
                <c:pt idx="1">
                  <c:v>0.82359101726758255</c:v>
                </c:pt>
                <c:pt idx="2">
                  <c:v>0.28917204597632201</c:v>
                </c:pt>
                <c:pt idx="3">
                  <c:v>0.55095255793830489</c:v>
                </c:pt>
                <c:pt idx="4">
                  <c:v>1.2311444133449068</c:v>
                </c:pt>
                <c:pt idx="5">
                  <c:v>0.90751915531715721</c:v>
                </c:pt>
                <c:pt idx="6">
                  <c:v>0.6643429070482566</c:v>
                </c:pt>
                <c:pt idx="7">
                  <c:v>0.76843759064400485</c:v>
                </c:pt>
                <c:pt idx="8">
                  <c:v>0.65067092772096713</c:v>
                </c:pt>
                <c:pt idx="9">
                  <c:v>0.93952274921401158</c:v>
                </c:pt>
              </c:numCache>
            </c:numRef>
          </c:val>
        </c:ser>
        <c:marker val="1"/>
        <c:axId val="82729600"/>
        <c:axId val="82743680"/>
      </c:lineChart>
      <c:catAx>
        <c:axId val="82729600"/>
        <c:scaling>
          <c:orientation val="minMax"/>
        </c:scaling>
        <c:axPos val="b"/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743680"/>
        <c:crosses val="autoZero"/>
        <c:auto val="1"/>
        <c:lblAlgn val="ctr"/>
        <c:lblOffset val="100"/>
      </c:catAx>
      <c:valAx>
        <c:axId val="82743680"/>
        <c:scaling>
          <c:orientation val="minMax"/>
        </c:scaling>
        <c:axPos val="l"/>
        <c:majorGridlines>
          <c:spPr>
            <a:ln w="12700">
              <a:solidFill>
                <a:srgbClr val="000000"/>
              </a:solidFill>
              <a:prstDash val="sysDot"/>
            </a:ln>
          </c:spPr>
        </c:majorGridlines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729600"/>
        <c:crosses val="autoZero"/>
        <c:crossBetween val="between"/>
      </c:valAx>
      <c:spPr>
        <a:ln w="19050">
          <a:solidFill>
            <a:srgbClr val="000000"/>
          </a:solidFill>
        </a:ln>
      </c:spPr>
    </c:plotArea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lineChart>
        <c:grouping val="standard"/>
        <c:ser>
          <c:idx val="0"/>
          <c:order val="0"/>
          <c:spPr>
            <a:ln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R$36:$R$45</c:f>
                <c:numCache>
                  <c:formatCode>General</c:formatCode>
                  <c:ptCount val="10"/>
                  <c:pt idx="0">
                    <c:v>2.8113826656066546E-2</c:v>
                  </c:pt>
                  <c:pt idx="1">
                    <c:v>2.1012125707193411E-2</c:v>
                  </c:pt>
                  <c:pt idx="2">
                    <c:v>2.8991493851485917E-2</c:v>
                  </c:pt>
                  <c:pt idx="3">
                    <c:v>5.7018040561380282E-2</c:v>
                  </c:pt>
                  <c:pt idx="4">
                    <c:v>4.1244964693786856E-2</c:v>
                  </c:pt>
                  <c:pt idx="5">
                    <c:v>6.1011311843640552E-2</c:v>
                  </c:pt>
                  <c:pt idx="6">
                    <c:v>5.8823494418713484E-2</c:v>
                  </c:pt>
                  <c:pt idx="7">
                    <c:v>3.8032524459856276E-2</c:v>
                  </c:pt>
                  <c:pt idx="8">
                    <c:v>6.1440316600586797E-2</c:v>
                  </c:pt>
                  <c:pt idx="9">
                    <c:v>0.10956947206784506</c:v>
                  </c:pt>
                </c:numCache>
              </c:numRef>
            </c:plus>
            <c:minus>
              <c:numRef>
                <c:f>Sheet1!$S$36:$S$45</c:f>
                <c:numCache>
                  <c:formatCode>General</c:formatCode>
                  <c:ptCount val="10"/>
                  <c:pt idx="0">
                    <c:v>2.7345052587714868E-2</c:v>
                  </c:pt>
                  <c:pt idx="1">
                    <c:v>2.0579702413073699E-2</c:v>
                  </c:pt>
                  <c:pt idx="2">
                    <c:v>2.8174668133525316E-2</c:v>
                  </c:pt>
                  <c:pt idx="3">
                    <c:v>5.3942353274403956E-2</c:v>
                  </c:pt>
                  <c:pt idx="4">
                    <c:v>3.9611202063211663E-2</c:v>
                  </c:pt>
                  <c:pt idx="5">
                    <c:v>5.7502979621984592E-2</c:v>
                  </c:pt>
                  <c:pt idx="6">
                    <c:v>5.5555524342616534E-2</c:v>
                  </c:pt>
                  <c:pt idx="7">
                    <c:v>3.6639048935048241E-2</c:v>
                  </c:pt>
                  <c:pt idx="8">
                    <c:v>5.7883910795247163E-2</c:v>
                  </c:pt>
                  <c:pt idx="9">
                    <c:v>9.8749537389169847E-2</c:v>
                  </c:pt>
                </c:numCache>
              </c:numRef>
            </c:minus>
          </c:errBars>
          <c:cat>
            <c:numRef>
              <c:f>Sheet1!$P$36:$P$45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24</c:v>
                </c:pt>
                <c:pt idx="5">
                  <c:v>26</c:v>
                </c:pt>
                <c:pt idx="6">
                  <c:v>28</c:v>
                </c:pt>
                <c:pt idx="7">
                  <c:v>32</c:v>
                </c:pt>
                <c:pt idx="8">
                  <c:v>36</c:v>
                </c:pt>
                <c:pt idx="9">
                  <c:v>48</c:v>
                </c:pt>
              </c:numCache>
            </c:numRef>
          </c:cat>
          <c:val>
            <c:numRef>
              <c:f>Sheet1!$Q$36:$Q$45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0.99999999999999845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spPr>
            <a:ln>
              <a:solidFill>
                <a:prstClr val="white">
                  <a:lumMod val="50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R$47:$R$56</c:f>
                <c:numCache>
                  <c:formatCode>General</c:formatCode>
                  <c:ptCount val="10"/>
                  <c:pt idx="0">
                    <c:v>0.11719835655209375</c:v>
                  </c:pt>
                  <c:pt idx="1">
                    <c:v>7.5918420468021594E-2</c:v>
                  </c:pt>
                  <c:pt idx="2">
                    <c:v>2.93725429945654E-2</c:v>
                  </c:pt>
                  <c:pt idx="3">
                    <c:v>6.7103708073456461E-2</c:v>
                  </c:pt>
                  <c:pt idx="4">
                    <c:v>6.1891776147635934E-2</c:v>
                  </c:pt>
                  <c:pt idx="5">
                    <c:v>1.9782407366793809E-2</c:v>
                  </c:pt>
                  <c:pt idx="6">
                    <c:v>6.9821305324746424E-2</c:v>
                  </c:pt>
                  <c:pt idx="7">
                    <c:v>3.3392376862230004E-2</c:v>
                  </c:pt>
                  <c:pt idx="8">
                    <c:v>2.8746622382980425E-2</c:v>
                  </c:pt>
                  <c:pt idx="9">
                    <c:v>6.2865665672094173E-2</c:v>
                  </c:pt>
                </c:numCache>
              </c:numRef>
            </c:plus>
            <c:minus>
              <c:numRef>
                <c:f>Sheet1!$S$47:$S$56</c:f>
                <c:numCache>
                  <c:formatCode>General</c:formatCode>
                  <c:ptCount val="10"/>
                  <c:pt idx="0">
                    <c:v>0.10931213622556357</c:v>
                  </c:pt>
                  <c:pt idx="1">
                    <c:v>6.8829575878581961E-2</c:v>
                  </c:pt>
                  <c:pt idx="2">
                    <c:v>2.5771715130480211E-2</c:v>
                  </c:pt>
                  <c:pt idx="3">
                    <c:v>6.33757263861017E-2</c:v>
                  </c:pt>
                  <c:pt idx="4">
                    <c:v>5.5240850423338497E-2</c:v>
                  </c:pt>
                  <c:pt idx="5">
                    <c:v>1.8998802431290762E-2</c:v>
                  </c:pt>
                  <c:pt idx="6">
                    <c:v>6.4399446590294507E-2</c:v>
                  </c:pt>
                  <c:pt idx="7">
                    <c:v>3.2568183946683808E-2</c:v>
                  </c:pt>
                  <c:pt idx="8">
                    <c:v>2.8304506602313095E-2</c:v>
                  </c:pt>
                  <c:pt idx="9">
                    <c:v>5.8973910219500936E-2</c:v>
                  </c:pt>
                </c:numCache>
              </c:numRef>
            </c:minus>
          </c:errBars>
          <c:val>
            <c:numRef>
              <c:f>Sheet1!$Q$47:$Q$56</c:f>
              <c:numCache>
                <c:formatCode>General</c:formatCode>
                <c:ptCount val="10"/>
                <c:pt idx="0">
                  <c:v>1.6245047927124583</c:v>
                </c:pt>
                <c:pt idx="1">
                  <c:v>0.7371346086455558</c:v>
                </c:pt>
                <c:pt idx="2">
                  <c:v>0.21022410381342974</c:v>
                </c:pt>
                <c:pt idx="3">
                  <c:v>1.1407637158684238</c:v>
                </c:pt>
                <c:pt idx="4">
                  <c:v>0.5140569133280336</c:v>
                </c:pt>
                <c:pt idx="5">
                  <c:v>0.47963205966263217</c:v>
                </c:pt>
                <c:pt idx="6">
                  <c:v>0.82931954581444156</c:v>
                </c:pt>
                <c:pt idx="7">
                  <c:v>1.3195079107728942</c:v>
                </c:pt>
                <c:pt idx="8">
                  <c:v>1.8403753012497501</c:v>
                </c:pt>
                <c:pt idx="9">
                  <c:v>0.95263799804393934</c:v>
                </c:pt>
              </c:numCache>
            </c:numRef>
          </c:val>
        </c:ser>
        <c:ser>
          <c:idx val="2"/>
          <c:order val="2"/>
          <c:spPr>
            <a:ln>
              <a:solidFill>
                <a:prstClr val="black">
                  <a:lumMod val="95000"/>
                  <a:lumOff val="5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R$58:$R$67</c:f>
                <c:numCache>
                  <c:formatCode>General</c:formatCode>
                  <c:ptCount val="10"/>
                  <c:pt idx="0">
                    <c:v>0.14551273633951545</c:v>
                  </c:pt>
                  <c:pt idx="1">
                    <c:v>0.11920802237497929</c:v>
                  </c:pt>
                  <c:pt idx="2">
                    <c:v>5.149793171414483E-2</c:v>
                  </c:pt>
                  <c:pt idx="3">
                    <c:v>0.12070809471423116</c:v>
                  </c:pt>
                  <c:pt idx="4">
                    <c:v>8.6169216104675317E-2</c:v>
                  </c:pt>
                  <c:pt idx="5">
                    <c:v>5.2590425860849124E-2</c:v>
                  </c:pt>
                  <c:pt idx="6">
                    <c:v>0.16026963100227226</c:v>
                  </c:pt>
                  <c:pt idx="7">
                    <c:v>6.6425973701517815E-2</c:v>
                  </c:pt>
                  <c:pt idx="8">
                    <c:v>7.9295209095505484E-2</c:v>
                  </c:pt>
                  <c:pt idx="9">
                    <c:v>7.6887231487792432E-2</c:v>
                  </c:pt>
                </c:numCache>
              </c:numRef>
            </c:plus>
            <c:minus>
              <c:numRef>
                <c:f>Sheet1!$S$58:$S$67</c:f>
                <c:numCache>
                  <c:formatCode>General</c:formatCode>
                  <c:ptCount val="10"/>
                  <c:pt idx="0">
                    <c:v>0.12955052731072067</c:v>
                  </c:pt>
                  <c:pt idx="1">
                    <c:v>0.10697519694337522</c:v>
                  </c:pt>
                  <c:pt idx="2">
                    <c:v>4.7123673448300922E-2</c:v>
                  </c:pt>
                  <c:pt idx="3">
                    <c:v>0.11262463471392772</c:v>
                  </c:pt>
                  <c:pt idx="4">
                    <c:v>7.6575277810779774E-2</c:v>
                  </c:pt>
                  <c:pt idx="5">
                    <c:v>4.8854746049200704E-2</c:v>
                  </c:pt>
                  <c:pt idx="6">
                    <c:v>0.14236761473753723</c:v>
                  </c:pt>
                  <c:pt idx="7">
                    <c:v>6.3157163192656851E-2</c:v>
                  </c:pt>
                  <c:pt idx="8">
                    <c:v>7.6389908049140184E-2</c:v>
                  </c:pt>
                  <c:pt idx="9">
                    <c:v>7.1639915828254908E-2</c:v>
                  </c:pt>
                </c:numCache>
              </c:numRef>
            </c:minus>
          </c:errBars>
          <c:val>
            <c:numRef>
              <c:f>Sheet1!$Q$58:$Q$67</c:f>
              <c:numCache>
                <c:formatCode>General</c:formatCode>
                <c:ptCount val="10"/>
                <c:pt idx="0">
                  <c:v>1.1809926614295321</c:v>
                </c:pt>
                <c:pt idx="1">
                  <c:v>1.0424657608411221</c:v>
                </c:pt>
                <c:pt idx="2">
                  <c:v>0.55478473603392264</c:v>
                </c:pt>
                <c:pt idx="3">
                  <c:v>1.6817928305074286</c:v>
                </c:pt>
                <c:pt idx="4">
                  <c:v>0.68777090906987814</c:v>
                </c:pt>
                <c:pt idx="5">
                  <c:v>0.68777090906987681</c:v>
                </c:pt>
                <c:pt idx="6">
                  <c:v>1.2745606273192618</c:v>
                </c:pt>
                <c:pt idx="7">
                  <c:v>1.2834258975628929</c:v>
                </c:pt>
                <c:pt idx="8">
                  <c:v>2.0849315216822633</c:v>
                </c:pt>
                <c:pt idx="9">
                  <c:v>1.0497166836230658</c:v>
                </c:pt>
              </c:numCache>
            </c:numRef>
          </c:val>
        </c:ser>
        <c:marker val="1"/>
        <c:axId val="82642816"/>
        <c:axId val="82644352"/>
      </c:lineChart>
      <c:catAx>
        <c:axId val="82642816"/>
        <c:scaling>
          <c:orientation val="minMax"/>
        </c:scaling>
        <c:axPos val="b"/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644352"/>
        <c:crosses val="autoZero"/>
        <c:auto val="1"/>
        <c:lblAlgn val="ctr"/>
        <c:lblOffset val="100"/>
      </c:catAx>
      <c:valAx>
        <c:axId val="82644352"/>
        <c:scaling>
          <c:orientation val="minMax"/>
        </c:scaling>
        <c:axPos val="l"/>
        <c:majorGridlines>
          <c:spPr>
            <a:ln w="12700">
              <a:solidFill>
                <a:srgbClr val="000000"/>
              </a:solidFill>
              <a:prstDash val="sysDot"/>
            </a:ln>
          </c:spPr>
        </c:majorGridlines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642816"/>
        <c:crosses val="autoZero"/>
        <c:crossBetween val="between"/>
      </c:valAx>
      <c:spPr>
        <a:ln w="19050">
          <a:solidFill>
            <a:srgbClr val="000000"/>
          </a:solidFill>
        </a:ln>
      </c:spPr>
    </c:plotArea>
    <c:plotVisOnly val="1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lineChart>
        <c:grouping val="standard"/>
        <c:ser>
          <c:idx val="0"/>
          <c:order val="0"/>
          <c:spPr>
            <a:ln w="28575"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T$41:$T$50</c:f>
                <c:numCache>
                  <c:formatCode>General</c:formatCode>
                  <c:ptCount val="10"/>
                  <c:pt idx="0">
                    <c:v>8.4512738762955175E-2</c:v>
                  </c:pt>
                  <c:pt idx="1">
                    <c:v>8.6734862526059719E-2</c:v>
                  </c:pt>
                  <c:pt idx="2">
                    <c:v>7.0651220006819004E-2</c:v>
                  </c:pt>
                  <c:pt idx="3">
                    <c:v>8.6734862526059719E-2</c:v>
                  </c:pt>
                  <c:pt idx="4">
                    <c:v>4.1244964693786856E-2</c:v>
                  </c:pt>
                  <c:pt idx="5">
                    <c:v>6.7576764668209721E-2</c:v>
                  </c:pt>
                  <c:pt idx="6">
                    <c:v>9.5454425236114068E-2</c:v>
                  </c:pt>
                  <c:pt idx="7">
                    <c:v>9.4293701260739438E-2</c:v>
                  </c:pt>
                  <c:pt idx="8">
                    <c:v>7.1027073698357576E-2</c:v>
                  </c:pt>
                  <c:pt idx="9">
                    <c:v>6.4370182453359792E-2</c:v>
                  </c:pt>
                </c:numCache>
              </c:numRef>
            </c:plus>
            <c:minus>
              <c:numRef>
                <c:f>Sheet1!$U$41:$U$50</c:f>
                <c:numCache>
                  <c:formatCode>General</c:formatCode>
                  <c:ptCount val="10"/>
                  <c:pt idx="0">
                    <c:v>7.7926921226720708E-2</c:v>
                  </c:pt>
                  <c:pt idx="1">
                    <c:v>7.9812349375124839E-2</c:v>
                  </c:pt>
                  <c:pt idx="2">
                    <c:v>6.5989015551085828E-2</c:v>
                  </c:pt>
                  <c:pt idx="3">
                    <c:v>7.9812349375124839E-2</c:v>
                  </c:pt>
                  <c:pt idx="4">
                    <c:v>3.9611202063211663E-2</c:v>
                  </c:pt>
                  <c:pt idx="5">
                    <c:v>6.3299208923127709E-2</c:v>
                  </c:pt>
                  <c:pt idx="6">
                    <c:v>8.7136829280268224E-2</c:v>
                  </c:pt>
                  <c:pt idx="7">
                    <c:v>8.6168549770599748E-2</c:v>
                  </c:pt>
                  <c:pt idx="8">
                    <c:v>6.6316786421742824E-2</c:v>
                  </c:pt>
                  <c:pt idx="9">
                    <c:v>6.047725078598809E-2</c:v>
                  </c:pt>
                </c:numCache>
              </c:numRef>
            </c:minus>
          </c:errBars>
          <c:cat>
            <c:numRef>
              <c:f>Sheet1!$R$41:$R$50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24</c:v>
                </c:pt>
                <c:pt idx="5">
                  <c:v>26</c:v>
                </c:pt>
                <c:pt idx="6">
                  <c:v>28</c:v>
                </c:pt>
                <c:pt idx="7">
                  <c:v>32</c:v>
                </c:pt>
                <c:pt idx="8">
                  <c:v>36</c:v>
                </c:pt>
                <c:pt idx="9">
                  <c:v>48</c:v>
                </c:pt>
              </c:numCache>
            </c:numRef>
          </c:cat>
          <c:val>
            <c:numRef>
              <c:f>Sheet1!$S$41:$S$50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spPr>
            <a:ln w="28575">
              <a:solidFill>
                <a:schemeClr val="bg1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T$52:$T$61</c:f>
                <c:numCache>
                  <c:formatCode>General</c:formatCode>
                  <c:ptCount val="10"/>
                  <c:pt idx="0">
                    <c:v>4.4016302016751399E-2</c:v>
                  </c:pt>
                  <c:pt idx="1">
                    <c:v>9.1167681972795539E-2</c:v>
                  </c:pt>
                  <c:pt idx="2">
                    <c:v>1.5297319059502261E-2</c:v>
                  </c:pt>
                  <c:pt idx="3">
                    <c:v>6.7029686176190428E-2</c:v>
                  </c:pt>
                  <c:pt idx="4">
                    <c:v>8.5837738379925352E-2</c:v>
                  </c:pt>
                  <c:pt idx="5">
                    <c:v>2.922562146204144E-2</c:v>
                  </c:pt>
                  <c:pt idx="6">
                    <c:v>9.3415848305113389E-2</c:v>
                  </c:pt>
                  <c:pt idx="7">
                    <c:v>3.8297061587520505E-2</c:v>
                  </c:pt>
                  <c:pt idx="8">
                    <c:v>0.11725780617573008</c:v>
                  </c:pt>
                  <c:pt idx="9">
                    <c:v>2.9475551109557019E-2</c:v>
                  </c:pt>
                </c:numCache>
              </c:numRef>
            </c:plus>
            <c:minus>
              <c:numRef>
                <c:f>Sheet1!$U$52:$U$61</c:f>
                <c:numCache>
                  <c:formatCode>General</c:formatCode>
                  <c:ptCount val="10"/>
                  <c:pt idx="0">
                    <c:v>4.3061995244307004E-2</c:v>
                  </c:pt>
                  <c:pt idx="1">
                    <c:v>8.1794154073023706E-2</c:v>
                  </c:pt>
                  <c:pt idx="2">
                    <c:v>1.2945466395228861E-2</c:v>
                  </c:pt>
                  <c:pt idx="3">
                    <c:v>6.2268335771992485E-2</c:v>
                  </c:pt>
                  <c:pt idx="4">
                    <c:v>7.8420346527176887E-2</c:v>
                  </c:pt>
                  <c:pt idx="5">
                    <c:v>2.8154822487136192E-2</c:v>
                  </c:pt>
                  <c:pt idx="6">
                    <c:v>8.6161794106131451E-2</c:v>
                  </c:pt>
                  <c:pt idx="7">
                    <c:v>3.6893893673946652E-2</c:v>
                  </c:pt>
                  <c:pt idx="8">
                    <c:v>0.10712535030475349</c:v>
                  </c:pt>
                  <c:pt idx="9">
                    <c:v>2.8748033553483099E-2</c:v>
                  </c:pt>
                </c:numCache>
              </c:numRef>
            </c:minus>
          </c:errBars>
          <c:val>
            <c:numRef>
              <c:f>Sheet1!$S$52:$S$61</c:f>
              <c:numCache>
                <c:formatCode>General</c:formatCode>
                <c:ptCount val="10"/>
                <c:pt idx="0">
                  <c:v>1.9861849908740707</c:v>
                </c:pt>
                <c:pt idx="1">
                  <c:v>0.79553648375491215</c:v>
                </c:pt>
                <c:pt idx="2">
                  <c:v>8.4202098554105556E-2</c:v>
                </c:pt>
                <c:pt idx="3">
                  <c:v>0.87660572131603565</c:v>
                </c:pt>
                <c:pt idx="4">
                  <c:v>0.90751915531715632</c:v>
                </c:pt>
                <c:pt idx="5">
                  <c:v>0.76843759064400563</c:v>
                </c:pt>
                <c:pt idx="6">
                  <c:v>1.1095694720678366</c:v>
                </c:pt>
                <c:pt idx="7">
                  <c:v>1.0069555500567264</c:v>
                </c:pt>
                <c:pt idx="8">
                  <c:v>1.2397076999389858</c:v>
                </c:pt>
                <c:pt idx="9">
                  <c:v>1.164733586468458</c:v>
                </c:pt>
              </c:numCache>
            </c:numRef>
          </c:val>
        </c:ser>
        <c:ser>
          <c:idx val="2"/>
          <c:order val="2"/>
          <c:spPr>
            <a:ln w="28575">
              <a:solidFill>
                <a:schemeClr val="tx1">
                  <a:lumMod val="95000"/>
                  <a:lumOff val="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T$72:$T$81</c:f>
                <c:numCache>
                  <c:formatCode>General</c:formatCode>
                  <c:ptCount val="10"/>
                  <c:pt idx="0">
                    <c:v>0.21744286597359741</c:v>
                  </c:pt>
                  <c:pt idx="1">
                    <c:v>0.17118468457536401</c:v>
                  </c:pt>
                  <c:pt idx="2">
                    <c:v>2.6556715946458087E-2</c:v>
                  </c:pt>
                  <c:pt idx="3">
                    <c:v>6.6179874604673075E-2</c:v>
                  </c:pt>
                  <c:pt idx="4">
                    <c:v>8.9816641475231523E-2</c:v>
                  </c:pt>
                  <c:pt idx="5">
                    <c:v>7.2023639158631039E-2</c:v>
                  </c:pt>
                  <c:pt idx="6">
                    <c:v>3.8012686279271575E-2</c:v>
                  </c:pt>
                  <c:pt idx="7">
                    <c:v>9.0774115566045768E-2</c:v>
                  </c:pt>
                  <c:pt idx="8">
                    <c:v>0.15293132947856244</c:v>
                  </c:pt>
                  <c:pt idx="9">
                    <c:v>0.12841519634749796</c:v>
                  </c:pt>
                </c:numCache>
              </c:numRef>
            </c:plus>
            <c:minus>
              <c:numRef>
                <c:f>Sheet1!$U$72:$U$81</c:f>
                <c:numCache>
                  <c:formatCode>General</c:formatCode>
                  <c:ptCount val="10"/>
                  <c:pt idx="0">
                    <c:v>0.19208580893230653</c:v>
                  </c:pt>
                  <c:pt idx="1">
                    <c:v>0.15546924281078181</c:v>
                  </c:pt>
                  <c:pt idx="2">
                    <c:v>2.5029625650562159E-2</c:v>
                  </c:pt>
                  <c:pt idx="3">
                    <c:v>6.2177497731221644E-2</c:v>
                  </c:pt>
                  <c:pt idx="4">
                    <c:v>8.2600603165287265E-2</c:v>
                  </c:pt>
                  <c:pt idx="5">
                    <c:v>6.8320226873093734E-2</c:v>
                  </c:pt>
                  <c:pt idx="6">
                    <c:v>3.6443293745267183E-2</c:v>
                  </c:pt>
                  <c:pt idx="7">
                    <c:v>8.3409714051061679E-2</c:v>
                  </c:pt>
                  <c:pt idx="8">
                    <c:v>0.13960537833018447</c:v>
                  </c:pt>
                  <c:pt idx="9">
                    <c:v>0.11965125651408172</c:v>
                  </c:pt>
                </c:numCache>
              </c:numRef>
            </c:minus>
          </c:errBars>
          <c:val>
            <c:numRef>
              <c:f>Sheet1!$S$72:$S$81</c:f>
              <c:numCache>
                <c:formatCode>General</c:formatCode>
                <c:ptCount val="10"/>
                <c:pt idx="0">
                  <c:v>1.6471820345351549</c:v>
                </c:pt>
                <c:pt idx="1">
                  <c:v>1.6934906247250541</c:v>
                </c:pt>
                <c:pt idx="2">
                  <c:v>0.43527528164806434</c:v>
                </c:pt>
                <c:pt idx="3">
                  <c:v>1.0281138266560792</c:v>
                </c:pt>
                <c:pt idx="4">
                  <c:v>1.0281138266560805</c:v>
                </c:pt>
                <c:pt idx="5">
                  <c:v>1.3286858140965245</c:v>
                </c:pt>
                <c:pt idx="6">
                  <c:v>0.88270299629065552</c:v>
                </c:pt>
                <c:pt idx="7">
                  <c:v>1.0281138266560781</c:v>
                </c:pt>
                <c:pt idx="8">
                  <c:v>1.6021397551792438</c:v>
                </c:pt>
                <c:pt idx="9">
                  <c:v>1.7532114426320606</c:v>
                </c:pt>
              </c:numCache>
            </c:numRef>
          </c:val>
        </c:ser>
        <c:marker val="1"/>
        <c:axId val="82850944"/>
        <c:axId val="82852480"/>
      </c:lineChart>
      <c:catAx>
        <c:axId val="82850944"/>
        <c:scaling>
          <c:orientation val="minMax"/>
        </c:scaling>
        <c:axPos val="b"/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852480"/>
        <c:crosses val="autoZero"/>
        <c:auto val="1"/>
        <c:lblAlgn val="ctr"/>
        <c:lblOffset val="100"/>
      </c:catAx>
      <c:valAx>
        <c:axId val="82852480"/>
        <c:scaling>
          <c:orientation val="minMax"/>
        </c:scaling>
        <c:axPos val="l"/>
        <c:majorGridlines>
          <c:spPr>
            <a:ln w="12700">
              <a:solidFill>
                <a:srgbClr val="000000"/>
              </a:solidFill>
              <a:prstDash val="sysDot"/>
            </a:ln>
          </c:spPr>
        </c:majorGridlines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850944"/>
        <c:crosses val="autoZero"/>
        <c:crossBetween val="between"/>
      </c:valAx>
      <c:spPr>
        <a:ln w="19050">
          <a:solidFill>
            <a:srgbClr val="000000"/>
          </a:solidFill>
        </a:ln>
      </c:spPr>
    </c:plotArea>
    <c:plotVisOnly val="1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/>
      <c:lineChart>
        <c:grouping val="standard"/>
        <c:ser>
          <c:idx val="0"/>
          <c:order val="0"/>
          <c:spPr>
            <a:ln>
              <a:solidFill>
                <a:schemeClr val="bg1">
                  <a:lumMod val="8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R$55:$R$64</c:f>
                <c:numCache>
                  <c:formatCode>General</c:formatCode>
                  <c:ptCount val="10"/>
                  <c:pt idx="0">
                    <c:v>3.5264923841377582E-2</c:v>
                  </c:pt>
                  <c:pt idx="1">
                    <c:v>7.1773462536293131E-2</c:v>
                  </c:pt>
                  <c:pt idx="2">
                    <c:v>3.5264923841377582E-2</c:v>
                  </c:pt>
                  <c:pt idx="3">
                    <c:v>6.4370182453359792E-2</c:v>
                  </c:pt>
                  <c:pt idx="4">
                    <c:v>5.4206674290118807E-2</c:v>
                  </c:pt>
                  <c:pt idx="5">
                    <c:v>6.1011311843640552E-2</c:v>
                  </c:pt>
                  <c:pt idx="6">
                    <c:v>0.11825185765274958</c:v>
                  </c:pt>
                  <c:pt idx="7">
                    <c:v>6.7576764668209721E-2</c:v>
                  </c:pt>
                  <c:pt idx="8">
                    <c:v>6.5991138083067336E-2</c:v>
                  </c:pt>
                  <c:pt idx="9">
                    <c:v>6.7967933557977395E-2</c:v>
                  </c:pt>
                </c:numCache>
              </c:numRef>
            </c:plus>
            <c:minus>
              <c:numRef>
                <c:f>Sheet1!$S$55:$S$64</c:f>
                <c:numCache>
                  <c:formatCode>General</c:formatCode>
                  <c:ptCount val="10"/>
                  <c:pt idx="0">
                    <c:v>3.4063671075154602E-2</c:v>
                  </c:pt>
                  <c:pt idx="1">
                    <c:v>6.6967008463192576E-2</c:v>
                  </c:pt>
                  <c:pt idx="2">
                    <c:v>3.4063671075154602E-2</c:v>
                  </c:pt>
                  <c:pt idx="3">
                    <c:v>6.047725078598809E-2</c:v>
                  </c:pt>
                  <c:pt idx="4">
                    <c:v>5.1419399641554946E-2</c:v>
                  </c:pt>
                  <c:pt idx="5">
                    <c:v>5.7502979621984592E-2</c:v>
                  </c:pt>
                  <c:pt idx="6">
                    <c:v>0.10574707016446583</c:v>
                  </c:pt>
                  <c:pt idx="7">
                    <c:v>6.3299208923127709E-2</c:v>
                  </c:pt>
                  <c:pt idx="8">
                    <c:v>6.1905897455898917E-2</c:v>
                  </c:pt>
                  <c:pt idx="9">
                    <c:v>6.3642298071196701E-2</c:v>
                  </c:pt>
                </c:numCache>
              </c:numRef>
            </c:minus>
          </c:errBars>
          <c:cat>
            <c:numRef>
              <c:f>Sheet1!$P$55:$P$64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24</c:v>
                </c:pt>
                <c:pt idx="5">
                  <c:v>26</c:v>
                </c:pt>
                <c:pt idx="6">
                  <c:v>28</c:v>
                </c:pt>
                <c:pt idx="7">
                  <c:v>32</c:v>
                </c:pt>
                <c:pt idx="8">
                  <c:v>36</c:v>
                </c:pt>
                <c:pt idx="9">
                  <c:v>48</c:v>
                </c:pt>
              </c:numCache>
            </c:numRef>
          </c:cat>
          <c:val>
            <c:numRef>
              <c:f>Sheet1!$Q$55:$Q$64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spPr>
            <a:ln>
              <a:solidFill>
                <a:prstClr val="white">
                  <a:lumMod val="50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R$66:$R$75</c:f>
                <c:numCache>
                  <c:formatCode>General</c:formatCode>
                  <c:ptCount val="10"/>
                  <c:pt idx="0">
                    <c:v>3.6506784691565648E-3</c:v>
                  </c:pt>
                  <c:pt idx="1">
                    <c:v>0.13859836589489374</c:v>
                  </c:pt>
                  <c:pt idx="2">
                    <c:v>0.1267987111107009</c:v>
                  </c:pt>
                  <c:pt idx="3">
                    <c:v>0.10976852194028225</c:v>
                  </c:pt>
                  <c:pt idx="4">
                    <c:v>0.1097086935041619</c:v>
                  </c:pt>
                  <c:pt idx="5">
                    <c:v>1.611309824809783E-2</c:v>
                  </c:pt>
                  <c:pt idx="6">
                    <c:v>1.8160842819261523E-2</c:v>
                  </c:pt>
                  <c:pt idx="7">
                    <c:v>4.9430409813787934E-2</c:v>
                  </c:pt>
                  <c:pt idx="8">
                    <c:v>3.6442695518685252E-2</c:v>
                  </c:pt>
                  <c:pt idx="9">
                    <c:v>1.3410773539285763E-2</c:v>
                  </c:pt>
                </c:numCache>
              </c:numRef>
            </c:plus>
            <c:minus>
              <c:numRef>
                <c:f>Sheet1!$S$66:$S$75</c:f>
                <c:numCache>
                  <c:formatCode>General</c:formatCode>
                  <c:ptCount val="10"/>
                  <c:pt idx="0">
                    <c:v>3.6254613909728812E-3</c:v>
                  </c:pt>
                  <c:pt idx="1">
                    <c:v>0.12301751535616468</c:v>
                  </c:pt>
                  <c:pt idx="2">
                    <c:v>0.11125425068785059</c:v>
                  </c:pt>
                  <c:pt idx="3">
                    <c:v>0.10367027414757472</c:v>
                  </c:pt>
                  <c:pt idx="4">
                    <c:v>9.7047287290894929E-2</c:v>
                  </c:pt>
                  <c:pt idx="5">
                    <c:v>1.556422696937282E-2</c:v>
                  </c:pt>
                  <c:pt idx="6">
                    <c:v>1.7335736359412275E-2</c:v>
                  </c:pt>
                  <c:pt idx="7">
                    <c:v>4.8470756397149796E-2</c:v>
                  </c:pt>
                  <c:pt idx="8">
                    <c:v>3.5415934666555252E-2</c:v>
                  </c:pt>
                  <c:pt idx="9">
                    <c:v>1.3204519234564708E-2</c:v>
                  </c:pt>
                </c:numCache>
              </c:numRef>
            </c:minus>
          </c:errBars>
          <c:val>
            <c:numRef>
              <c:f>Sheet1!$Q$66:$Q$75</c:f>
              <c:numCache>
                <c:formatCode>General</c:formatCode>
                <c:ptCount val="10"/>
                <c:pt idx="0">
                  <c:v>0.52485834181153257</c:v>
                </c:pt>
                <c:pt idx="1">
                  <c:v>1.0942937012607401</c:v>
                </c:pt>
                <c:pt idx="2">
                  <c:v>0.90751915531715543</c:v>
                </c:pt>
                <c:pt idx="3">
                  <c:v>1.8660659830736201</c:v>
                </c:pt>
                <c:pt idx="4">
                  <c:v>0.84089641525372094</c:v>
                </c:pt>
                <c:pt idx="5">
                  <c:v>0.45691572511470213</c:v>
                </c:pt>
                <c:pt idx="6">
                  <c:v>0.38156480224014344</c:v>
                </c:pt>
                <c:pt idx="7">
                  <c:v>2.4966610978032167</c:v>
                </c:pt>
                <c:pt idx="8">
                  <c:v>1.2570133745218321</c:v>
                </c:pt>
                <c:pt idx="9">
                  <c:v>0.85856543643775474</c:v>
                </c:pt>
              </c:numCache>
            </c:numRef>
          </c:val>
        </c:ser>
        <c:ser>
          <c:idx val="2"/>
          <c:order val="2"/>
          <c:tx>
            <c:v>3</c:v>
          </c:tx>
          <c:spPr>
            <a:ln>
              <a:solidFill>
                <a:prstClr val="black">
                  <a:lumMod val="95000"/>
                  <a:lumOff val="5000"/>
                </a:prst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1!$R$77:$R$86</c:f>
                <c:numCache>
                  <c:formatCode>General</c:formatCode>
                  <c:ptCount val="10"/>
                  <c:pt idx="0">
                    <c:v>0.15400915067011323</c:v>
                  </c:pt>
                  <c:pt idx="1">
                    <c:v>5.4725604557601733E-2</c:v>
                  </c:pt>
                  <c:pt idx="2">
                    <c:v>6.7016414008307337E-2</c:v>
                  </c:pt>
                  <c:pt idx="3">
                    <c:v>0.1118466795357389</c:v>
                  </c:pt>
                  <c:pt idx="4">
                    <c:v>9.6198519463316354E-2</c:v>
                  </c:pt>
                  <c:pt idx="5">
                    <c:v>6.7663089294922804E-2</c:v>
                  </c:pt>
                  <c:pt idx="6">
                    <c:v>0.11421397871260262</c:v>
                  </c:pt>
                  <c:pt idx="7">
                    <c:v>0.15593972007641702</c:v>
                  </c:pt>
                  <c:pt idx="8">
                    <c:v>3.4331164356968591E-2</c:v>
                  </c:pt>
                  <c:pt idx="9">
                    <c:v>0.16847352343785488</c:v>
                  </c:pt>
                </c:numCache>
              </c:numRef>
            </c:plus>
            <c:minus>
              <c:numRef>
                <c:f>Sheet1!$S$77:$S$86</c:f>
                <c:numCache>
                  <c:formatCode>General</c:formatCode>
                  <c:ptCount val="10"/>
                  <c:pt idx="0">
                    <c:v>0.13781222557135403</c:v>
                  </c:pt>
                  <c:pt idx="1">
                    <c:v>5.0229078870205557E-2</c:v>
                  </c:pt>
                  <c:pt idx="2">
                    <c:v>6.13240086404514E-2</c:v>
                  </c:pt>
                  <c:pt idx="3">
                    <c:v>0.10435664200069014</c:v>
                  </c:pt>
                  <c:pt idx="4">
                    <c:v>8.9136399706238767E-2</c:v>
                  </c:pt>
                  <c:pt idx="5">
                    <c:v>6.3175890653516142E-2</c:v>
                  </c:pt>
                  <c:pt idx="6">
                    <c:v>0.10534487987236738</c:v>
                  </c:pt>
                  <c:pt idx="7">
                    <c:v>0.14746431444398644</c:v>
                  </c:pt>
                  <c:pt idx="8">
                    <c:v>3.3483800224664108E-2</c:v>
                  </c:pt>
                  <c:pt idx="9">
                    <c:v>0.15274239234050543</c:v>
                  </c:pt>
                </c:numCache>
              </c:numRef>
            </c:minus>
          </c:errBars>
          <c:val>
            <c:numRef>
              <c:f>Sheet1!$Q$77:$Q$86</c:f>
              <c:numCache>
                <c:formatCode>General</c:formatCode>
                <c:ptCount val="10"/>
                <c:pt idx="0">
                  <c:v>1.3103934038583647</c:v>
                </c:pt>
                <c:pt idx="1">
                  <c:v>0.61132013884603476</c:v>
                </c:pt>
                <c:pt idx="2">
                  <c:v>0.721964597761244</c:v>
                </c:pt>
                <c:pt idx="3">
                  <c:v>1.5583291593209978</c:v>
                </c:pt>
                <c:pt idx="4">
                  <c:v>1.2141948843950494</c:v>
                </c:pt>
                <c:pt idx="5">
                  <c:v>0.95263799804393767</c:v>
                </c:pt>
                <c:pt idx="6">
                  <c:v>1.3566043274476698</c:v>
                </c:pt>
                <c:pt idx="7">
                  <c:v>2.7132086548953436</c:v>
                </c:pt>
                <c:pt idx="8">
                  <c:v>1.3566043274476698</c:v>
                </c:pt>
                <c:pt idx="9">
                  <c:v>1.635804117115556</c:v>
                </c:pt>
              </c:numCache>
            </c:numRef>
          </c:val>
        </c:ser>
        <c:marker val="1"/>
        <c:axId val="82899328"/>
        <c:axId val="82900864"/>
      </c:lineChart>
      <c:catAx>
        <c:axId val="82899328"/>
        <c:scaling>
          <c:orientation val="minMax"/>
        </c:scaling>
        <c:axPos val="b"/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900864"/>
        <c:crosses val="autoZero"/>
        <c:auto val="1"/>
        <c:lblAlgn val="ctr"/>
        <c:lblOffset val="100"/>
      </c:catAx>
      <c:valAx>
        <c:axId val="82900864"/>
        <c:scaling>
          <c:orientation val="minMax"/>
        </c:scaling>
        <c:axPos val="l"/>
        <c:majorGridlines>
          <c:spPr>
            <a:ln w="12700">
              <a:solidFill>
                <a:srgbClr val="000000"/>
              </a:solidFill>
              <a:prstDash val="sysDot"/>
            </a:ln>
          </c:spPr>
        </c:majorGridlines>
        <c:numFmt formatCode="General" sourceLinked="1"/>
        <c:majorTickMark val="none"/>
        <c:tickLblPos val="none"/>
        <c:spPr>
          <a:ln w="19050">
            <a:solidFill>
              <a:srgbClr val="000000"/>
            </a:solidFill>
          </a:ln>
        </c:spPr>
        <c:crossAx val="82899328"/>
        <c:crosses val="autoZero"/>
        <c:crossBetween val="between"/>
      </c:valAx>
      <c:spPr>
        <a:noFill/>
        <a:ln w="19050">
          <a:solidFill>
            <a:srgbClr val="000000"/>
          </a:solidFill>
        </a:ln>
      </c:spPr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477AF7-3F74-4362-87B6-2F4CFFEBE32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FC55E2-C165-42C6-A7CC-543D9B6D67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276"/>
          <p:cNvGrpSpPr/>
          <p:nvPr/>
        </p:nvGrpSpPr>
        <p:grpSpPr>
          <a:xfrm>
            <a:off x="1042972" y="1507688"/>
            <a:ext cx="4743483" cy="5665785"/>
            <a:chOff x="971533" y="1507688"/>
            <a:chExt cx="4743483" cy="5665784"/>
          </a:xfrm>
        </p:grpSpPr>
        <p:grpSp>
          <p:nvGrpSpPr>
            <p:cNvPr id="11" name="组合 275"/>
            <p:cNvGrpSpPr/>
            <p:nvPr/>
          </p:nvGrpSpPr>
          <p:grpSpPr>
            <a:xfrm>
              <a:off x="971533" y="5673875"/>
              <a:ext cx="4740639" cy="1499597"/>
              <a:chOff x="971533" y="5740550"/>
              <a:chExt cx="4740639" cy="1499597"/>
            </a:xfrm>
          </p:grpSpPr>
          <p:graphicFrame>
            <p:nvGraphicFramePr>
              <p:cNvPr id="6" name="图表 5"/>
              <p:cNvGraphicFramePr/>
              <p:nvPr/>
            </p:nvGraphicFramePr>
            <p:xfrm>
              <a:off x="1296454" y="5740550"/>
              <a:ext cx="2033787" cy="1427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0" name="图表 9"/>
              <p:cNvGraphicFramePr/>
              <p:nvPr/>
            </p:nvGraphicFramePr>
            <p:xfrm>
              <a:off x="3609791" y="5740550"/>
              <a:ext cx="2033787" cy="1427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39" name="TextBox 138"/>
              <p:cNvSpPr txBox="1"/>
              <p:nvPr/>
            </p:nvSpPr>
            <p:spPr>
              <a:xfrm>
                <a:off x="3462580" y="5777995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5</a:t>
                </a:r>
                <a:endParaRPr lang="zh-CN" altLang="en-US" sz="800" b="1" dirty="0"/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3462580" y="5995227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0</a:t>
                </a:r>
                <a:endParaRPr lang="zh-CN" altLang="en-US" sz="800" b="1" dirty="0"/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3462580" y="6236264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5</a:t>
                </a:r>
                <a:endParaRPr lang="zh-CN" altLang="en-US" sz="800" b="1" dirty="0"/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3462580" y="647729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0</a:t>
                </a:r>
                <a:endParaRPr lang="zh-CN" altLang="en-US" sz="800" b="1" dirty="0"/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3462580" y="6718334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5</a:t>
                </a:r>
                <a:endParaRPr lang="zh-CN" altLang="en-US" sz="800" b="1" dirty="0"/>
              </a:p>
            </p:txBody>
          </p:sp>
          <p:sp>
            <p:nvSpPr>
              <p:cNvPr id="180" name="TextBox 179"/>
              <p:cNvSpPr txBox="1"/>
              <p:nvPr/>
            </p:nvSpPr>
            <p:spPr>
              <a:xfrm>
                <a:off x="1151989" y="57826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0</a:t>
                </a:r>
                <a:endParaRPr lang="zh-CN" altLang="en-US" sz="800" b="1" dirty="0"/>
              </a:p>
            </p:txBody>
          </p:sp>
          <p:sp>
            <p:nvSpPr>
              <p:cNvPr id="181" name="TextBox 180"/>
              <p:cNvSpPr txBox="1"/>
              <p:nvPr/>
            </p:nvSpPr>
            <p:spPr>
              <a:xfrm>
                <a:off x="1151989" y="607330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5</a:t>
                </a:r>
                <a:endParaRPr lang="zh-CN" altLang="en-US" sz="800" b="1" dirty="0"/>
              </a:p>
            </p:txBody>
          </p:sp>
          <p:sp>
            <p:nvSpPr>
              <p:cNvPr id="182" name="TextBox 181"/>
              <p:cNvSpPr txBox="1"/>
              <p:nvPr/>
            </p:nvSpPr>
            <p:spPr>
              <a:xfrm>
                <a:off x="1151989" y="6363934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0</a:t>
                </a:r>
                <a:endParaRPr lang="zh-CN" altLang="en-US" sz="800" b="1" dirty="0"/>
              </a:p>
            </p:txBody>
          </p:sp>
          <p:sp>
            <p:nvSpPr>
              <p:cNvPr id="183" name="TextBox 182"/>
              <p:cNvSpPr txBox="1"/>
              <p:nvPr/>
            </p:nvSpPr>
            <p:spPr>
              <a:xfrm>
                <a:off x="1151989" y="665456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5</a:t>
                </a:r>
                <a:endParaRPr lang="zh-CN" altLang="en-US" sz="800" b="1" dirty="0"/>
              </a:p>
            </p:txBody>
          </p:sp>
          <p:sp>
            <p:nvSpPr>
              <p:cNvPr id="187" name="TextBox 186"/>
              <p:cNvSpPr txBox="1"/>
              <p:nvPr/>
            </p:nvSpPr>
            <p:spPr>
              <a:xfrm>
                <a:off x="2087700" y="5873811"/>
                <a:ext cx="12024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i="1" dirty="0" smtClean="0">
                    <a:latin typeface="Arial" pitchFamily="34" charset="0"/>
                    <a:cs typeface="Arial" pitchFamily="34" charset="0"/>
                  </a:rPr>
                  <a:t>GmaPHO1; H9/H10</a:t>
                </a:r>
                <a:endParaRPr lang="zh-CN" altLang="en-US" sz="8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1" name="TextBox 190"/>
              <p:cNvSpPr txBox="1"/>
              <p:nvPr/>
            </p:nvSpPr>
            <p:spPr>
              <a:xfrm>
                <a:off x="4421301" y="5877781"/>
                <a:ext cx="116201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i="1" dirty="0" smtClean="0">
                    <a:latin typeface="Arial" pitchFamily="34" charset="0"/>
                    <a:cs typeface="Arial" pitchFamily="34" charset="0"/>
                  </a:rPr>
                  <a:t>GmaPHO1; H12/H14</a:t>
                </a:r>
                <a:endParaRPr lang="zh-CN" altLang="en-US" sz="8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01" name="直接连接符 200"/>
              <p:cNvCxnSpPr/>
              <p:nvPr/>
            </p:nvCxnSpPr>
            <p:spPr>
              <a:xfrm>
                <a:off x="2214554" y="5863178"/>
                <a:ext cx="0" cy="1190841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直接连接符 205"/>
              <p:cNvCxnSpPr/>
              <p:nvPr/>
            </p:nvCxnSpPr>
            <p:spPr>
              <a:xfrm>
                <a:off x="4526889" y="5869072"/>
                <a:ext cx="0" cy="1190841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TextBox 82"/>
              <p:cNvSpPr txBox="1"/>
              <p:nvPr/>
            </p:nvSpPr>
            <p:spPr>
              <a:xfrm>
                <a:off x="1071546" y="6913725"/>
                <a:ext cx="43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 smtClean="0"/>
                  <a:t>0</a:t>
                </a:r>
                <a:endParaRPr lang="zh-CN" altLang="en-US" sz="800" b="1" dirty="0"/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3375456" y="6922107"/>
                <a:ext cx="43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 smtClean="0"/>
                  <a:t>0</a:t>
                </a:r>
                <a:endParaRPr lang="zh-CN" altLang="en-US" sz="800" b="1" dirty="0"/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 rot="16200000">
                <a:off x="531831" y="6412418"/>
                <a:ext cx="115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Relative expression</a:t>
                </a:r>
                <a:endParaRPr lang="zh-CN" altLang="en-US" sz="800" b="1" dirty="0"/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 rot="16200000">
                <a:off x="2859577" y="6413772"/>
                <a:ext cx="115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Relative expression</a:t>
                </a:r>
                <a:endParaRPr lang="zh-CN" altLang="en-US" sz="800" b="1" dirty="0"/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971533" y="5773586"/>
                <a:ext cx="2535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d</a:t>
                </a:r>
                <a:endParaRPr lang="zh-CN" altLang="en-US" sz="1000" b="1" dirty="0"/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3286124" y="5773586"/>
                <a:ext cx="2535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h</a:t>
                </a:r>
                <a:endParaRPr lang="zh-CN" altLang="en-US" sz="1000" b="1" dirty="0"/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1739006" y="7024703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8</a:t>
                </a:r>
                <a:endParaRPr lang="zh-CN" altLang="en-US" sz="800" b="1" dirty="0"/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1908594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2</a:t>
                </a:r>
                <a:endParaRPr lang="zh-CN" altLang="en-US" sz="800" b="1" dirty="0"/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3052760" y="702470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(h)</a:t>
                </a:r>
                <a:endParaRPr lang="zh-CN" altLang="en-US" sz="800" b="1" dirty="0"/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1399830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</a:t>
                </a:r>
                <a:endParaRPr lang="zh-CN" altLang="en-US" sz="800" b="1" dirty="0"/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1569418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</a:t>
                </a:r>
                <a:endParaRPr lang="zh-CN" altLang="en-US" sz="800" b="1" dirty="0"/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2078182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4</a:t>
                </a:r>
                <a:endParaRPr lang="zh-CN" altLang="en-US" sz="800" b="1" dirty="0"/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2586946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2</a:t>
                </a:r>
                <a:endParaRPr lang="zh-CN" altLang="en-US" sz="800" b="1" dirty="0"/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2756534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6</a:t>
                </a:r>
                <a:endParaRPr lang="zh-CN" altLang="en-US" sz="800" b="1" dirty="0"/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2247770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6</a:t>
                </a:r>
                <a:endParaRPr lang="zh-CN" altLang="en-US" sz="800" b="1" dirty="0"/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2417358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8</a:t>
                </a:r>
                <a:endParaRPr lang="zh-CN" altLang="en-US" sz="800" b="1" dirty="0"/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2926124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8</a:t>
                </a:r>
                <a:endParaRPr lang="zh-CN" altLang="en-US" sz="800" b="1" dirty="0"/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4041228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8</a:t>
                </a:r>
                <a:endParaRPr lang="zh-CN" altLang="en-US" sz="800" b="1" dirty="0"/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4210816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2</a:t>
                </a:r>
                <a:endParaRPr lang="zh-CN" altLang="en-US" sz="800" b="1" dirty="0"/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>
                <a:off x="5354982" y="702470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(h)</a:t>
                </a:r>
                <a:endParaRPr lang="zh-CN" altLang="en-US" sz="800" b="1" dirty="0"/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3702052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</a:t>
                </a:r>
                <a:endParaRPr lang="zh-CN" altLang="en-US" sz="800" b="1" dirty="0"/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3871640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</a:t>
                </a:r>
                <a:endParaRPr lang="zh-CN" altLang="en-US" sz="800" b="1" dirty="0"/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4380404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4</a:t>
                </a:r>
                <a:endParaRPr lang="zh-CN" altLang="en-US" sz="800" b="1" dirty="0"/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4889168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2</a:t>
                </a:r>
                <a:endParaRPr lang="zh-CN" altLang="en-US" sz="800" b="1" dirty="0"/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5058756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6</a:t>
                </a:r>
                <a:endParaRPr lang="zh-CN" altLang="en-US" sz="800" b="1" dirty="0"/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4549992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6</a:t>
                </a:r>
                <a:endParaRPr lang="zh-CN" altLang="en-US" sz="800" b="1" dirty="0"/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4719580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8</a:t>
                </a:r>
                <a:endParaRPr lang="zh-CN" altLang="en-US" sz="800" b="1" dirty="0"/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5228346" y="702470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8</a:t>
                </a:r>
                <a:endParaRPr lang="zh-CN" altLang="en-US" sz="800" b="1" dirty="0"/>
              </a:p>
            </p:txBody>
          </p:sp>
        </p:grpSp>
        <p:grpSp>
          <p:nvGrpSpPr>
            <p:cNvPr id="12" name="组合 274"/>
            <p:cNvGrpSpPr/>
            <p:nvPr/>
          </p:nvGrpSpPr>
          <p:grpSpPr>
            <a:xfrm>
              <a:off x="971533" y="4275657"/>
              <a:ext cx="4743483" cy="1481790"/>
              <a:chOff x="971533" y="4329596"/>
              <a:chExt cx="4743483" cy="1481790"/>
            </a:xfrm>
          </p:grpSpPr>
          <p:graphicFrame>
            <p:nvGraphicFramePr>
              <p:cNvPr id="5" name="图表 4"/>
              <p:cNvGraphicFramePr/>
              <p:nvPr/>
            </p:nvGraphicFramePr>
            <p:xfrm>
              <a:off x="1296454" y="4329596"/>
              <a:ext cx="2033787" cy="1427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9" name="图表 8"/>
              <p:cNvGraphicFramePr/>
              <p:nvPr/>
            </p:nvGraphicFramePr>
            <p:xfrm>
              <a:off x="3609791" y="4329596"/>
              <a:ext cx="2033787" cy="1427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34" name="TextBox 133"/>
              <p:cNvSpPr txBox="1"/>
              <p:nvPr/>
            </p:nvSpPr>
            <p:spPr>
              <a:xfrm>
                <a:off x="3453615" y="435310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5</a:t>
                </a:r>
                <a:endParaRPr lang="zh-CN" altLang="en-US" sz="800" b="1" dirty="0"/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3453615" y="45703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0</a:t>
                </a:r>
                <a:endParaRPr lang="zh-CN" altLang="en-US" sz="800" b="1" dirty="0"/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3453615" y="4811377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5</a:t>
                </a:r>
                <a:endParaRPr lang="zh-CN" altLang="en-US" sz="800" b="1" dirty="0"/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>
                <a:off x="3453615" y="505241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0</a:t>
                </a:r>
                <a:endParaRPr lang="zh-CN" altLang="en-US" sz="800" b="1" dirty="0"/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>
                <a:off x="3453615" y="529344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5</a:t>
                </a:r>
                <a:endParaRPr lang="zh-CN" altLang="en-US" sz="800" b="1" dirty="0"/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>
                <a:off x="1160338" y="4360623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5</a:t>
                </a:r>
                <a:endParaRPr lang="zh-CN" altLang="en-US" sz="800" b="1" dirty="0"/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>
                <a:off x="1160338" y="4577856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0</a:t>
                </a:r>
                <a:endParaRPr lang="zh-CN" altLang="en-US" sz="800" b="1" dirty="0"/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1160338" y="4818891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5</a:t>
                </a:r>
                <a:endParaRPr lang="zh-CN" altLang="en-US" sz="800" b="1" dirty="0"/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1160338" y="5059926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0</a:t>
                </a:r>
                <a:endParaRPr lang="zh-CN" altLang="en-US" sz="800" b="1" dirty="0"/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>
                <a:off x="1160338" y="530096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5</a:t>
                </a:r>
                <a:endParaRPr lang="zh-CN" altLang="en-US" sz="800" b="1" dirty="0"/>
              </a:p>
            </p:txBody>
          </p:sp>
          <p:sp>
            <p:nvSpPr>
              <p:cNvPr id="186" name="TextBox 185"/>
              <p:cNvSpPr txBox="1"/>
              <p:nvPr/>
            </p:nvSpPr>
            <p:spPr>
              <a:xfrm>
                <a:off x="1989409" y="4476854"/>
                <a:ext cx="9881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i="1" dirty="0" smtClean="0">
                    <a:latin typeface="Arial" pitchFamily="34" charset="0"/>
                    <a:cs typeface="Arial" pitchFamily="34" charset="0"/>
                  </a:rPr>
                  <a:t>GmaPHO1; H6</a:t>
                </a:r>
                <a:endParaRPr lang="zh-CN" altLang="en-US" sz="8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" name="TextBox 189"/>
              <p:cNvSpPr txBox="1"/>
              <p:nvPr/>
            </p:nvSpPr>
            <p:spPr>
              <a:xfrm>
                <a:off x="4572007" y="4476854"/>
                <a:ext cx="9477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i="1" dirty="0" smtClean="0">
                    <a:latin typeface="Arial" pitchFamily="34" charset="0"/>
                    <a:cs typeface="Arial" pitchFamily="34" charset="0"/>
                  </a:rPr>
                  <a:t>GmaPHO1; H8</a:t>
                </a:r>
                <a:endParaRPr lang="zh-CN" altLang="en-US" sz="8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99" name="直接连接符 198"/>
              <p:cNvCxnSpPr/>
              <p:nvPr/>
            </p:nvCxnSpPr>
            <p:spPr>
              <a:xfrm>
                <a:off x="2214554" y="4445352"/>
                <a:ext cx="0" cy="1190841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直接连接符 204"/>
              <p:cNvCxnSpPr/>
              <p:nvPr/>
            </p:nvCxnSpPr>
            <p:spPr>
              <a:xfrm>
                <a:off x="4563015" y="4456108"/>
                <a:ext cx="0" cy="1190841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TextBox 81"/>
              <p:cNvSpPr txBox="1"/>
              <p:nvPr/>
            </p:nvSpPr>
            <p:spPr>
              <a:xfrm>
                <a:off x="1071546" y="5503979"/>
                <a:ext cx="43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 smtClean="0"/>
                  <a:t>0</a:t>
                </a:r>
                <a:endParaRPr lang="zh-CN" altLang="en-US" sz="800" b="1" dirty="0"/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3375456" y="5512360"/>
                <a:ext cx="43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 smtClean="0"/>
                  <a:t>0</a:t>
                </a:r>
                <a:endParaRPr lang="zh-CN" altLang="en-US" sz="800" b="1" dirty="0"/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 rot="16200000">
                <a:off x="531831" y="4992650"/>
                <a:ext cx="115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Relative expression</a:t>
                </a:r>
                <a:endParaRPr lang="zh-CN" altLang="en-US" sz="800" b="1" dirty="0"/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 rot="16200000">
                <a:off x="2859577" y="4994004"/>
                <a:ext cx="115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Relative expression</a:t>
                </a:r>
                <a:endParaRPr lang="zh-CN" altLang="en-US" sz="800" b="1" dirty="0"/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971533" y="4367208"/>
                <a:ext cx="2375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c</a:t>
                </a:r>
                <a:endParaRPr lang="zh-CN" altLang="en-US" sz="1000" b="1" dirty="0"/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3286124" y="4367208"/>
                <a:ext cx="2455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g</a:t>
                </a:r>
                <a:endParaRPr lang="zh-CN" altLang="en-US" sz="1000" b="1" dirty="0"/>
              </a:p>
            </p:txBody>
          </p:sp>
          <p:sp>
            <p:nvSpPr>
              <p:cNvPr id="176" name="TextBox 175"/>
              <p:cNvSpPr txBox="1"/>
              <p:nvPr/>
            </p:nvSpPr>
            <p:spPr>
              <a:xfrm>
                <a:off x="1741850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8</a:t>
                </a:r>
                <a:endParaRPr lang="zh-CN" altLang="en-US" sz="800" b="1" dirty="0"/>
              </a:p>
            </p:txBody>
          </p:sp>
          <p:sp>
            <p:nvSpPr>
              <p:cNvPr id="179" name="TextBox 178"/>
              <p:cNvSpPr txBox="1"/>
              <p:nvPr/>
            </p:nvSpPr>
            <p:spPr>
              <a:xfrm>
                <a:off x="1911438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2</a:t>
                </a:r>
                <a:endParaRPr lang="zh-CN" altLang="en-US" sz="800" b="1" dirty="0"/>
              </a:p>
            </p:txBody>
          </p:sp>
          <p:sp>
            <p:nvSpPr>
              <p:cNvPr id="194" name="TextBox 193"/>
              <p:cNvSpPr txBox="1"/>
              <p:nvPr/>
            </p:nvSpPr>
            <p:spPr>
              <a:xfrm>
                <a:off x="3055604" y="559594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(h)</a:t>
                </a:r>
                <a:endParaRPr lang="zh-CN" altLang="en-US" sz="800" b="1" dirty="0"/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1402674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</a:t>
                </a:r>
                <a:endParaRPr lang="zh-CN" altLang="en-US" sz="800" b="1" dirty="0"/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1572262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</a:t>
                </a:r>
                <a:endParaRPr lang="zh-CN" altLang="en-US" sz="800" b="1" dirty="0"/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2081026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4</a:t>
                </a:r>
                <a:endParaRPr lang="zh-CN" altLang="en-US" sz="800" b="1" dirty="0"/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2589790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2</a:t>
                </a:r>
                <a:endParaRPr lang="zh-CN" altLang="en-US" sz="800" b="1" dirty="0"/>
              </a:p>
            </p:txBody>
          </p:sp>
          <p:sp>
            <p:nvSpPr>
              <p:cNvPr id="202" name="TextBox 201"/>
              <p:cNvSpPr txBox="1"/>
              <p:nvPr/>
            </p:nvSpPr>
            <p:spPr>
              <a:xfrm>
                <a:off x="2759378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6</a:t>
                </a:r>
                <a:endParaRPr lang="zh-CN" altLang="en-US" sz="800" b="1" dirty="0"/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2250614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6</a:t>
                </a:r>
                <a:endParaRPr lang="zh-CN" altLang="en-US" sz="800" b="1" dirty="0"/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2420202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8</a:t>
                </a:r>
                <a:endParaRPr lang="zh-CN" altLang="en-US" sz="800" b="1" dirty="0"/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2928968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8</a:t>
                </a:r>
                <a:endParaRPr lang="zh-CN" altLang="en-US" sz="800" b="1" dirty="0"/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>
                <a:off x="4044072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8</a:t>
                </a:r>
                <a:endParaRPr lang="zh-CN" altLang="en-US" sz="800" b="1" dirty="0"/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4213660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2</a:t>
                </a:r>
                <a:endParaRPr lang="zh-CN" altLang="en-US" sz="800" b="1" dirty="0"/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5357826" y="559594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(h)</a:t>
                </a:r>
                <a:endParaRPr lang="zh-CN" altLang="en-US" sz="800" b="1" dirty="0"/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>
                <a:off x="3704896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</a:t>
                </a:r>
                <a:endParaRPr lang="zh-CN" altLang="en-US" sz="800" b="1" dirty="0"/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3874484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</a:t>
                </a:r>
                <a:endParaRPr lang="zh-CN" altLang="en-US" sz="800" b="1" dirty="0"/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>
                <a:off x="4383248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4</a:t>
                </a:r>
                <a:endParaRPr lang="zh-CN" altLang="en-US" sz="800" b="1" dirty="0"/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>
                <a:off x="4892012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2</a:t>
                </a:r>
                <a:endParaRPr lang="zh-CN" altLang="en-US" sz="800" b="1" dirty="0"/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5061600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6</a:t>
                </a:r>
                <a:endParaRPr lang="zh-CN" altLang="en-US" sz="800" b="1" dirty="0"/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4552836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6</a:t>
                </a:r>
                <a:endParaRPr lang="zh-CN" altLang="en-US" sz="800" b="1" dirty="0"/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4722424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8</a:t>
                </a:r>
                <a:endParaRPr lang="zh-CN" altLang="en-US" sz="800" b="1" dirty="0"/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5231190" y="559594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8</a:t>
                </a:r>
                <a:endParaRPr lang="zh-CN" altLang="en-US" sz="800" b="1" dirty="0"/>
              </a:p>
            </p:txBody>
          </p:sp>
        </p:grpSp>
        <p:grpSp>
          <p:nvGrpSpPr>
            <p:cNvPr id="13" name="组合 273"/>
            <p:cNvGrpSpPr/>
            <p:nvPr/>
          </p:nvGrpSpPr>
          <p:grpSpPr>
            <a:xfrm>
              <a:off x="971533" y="2889801"/>
              <a:ext cx="4740639" cy="1469429"/>
              <a:chOff x="971533" y="2913197"/>
              <a:chExt cx="4740639" cy="1469429"/>
            </a:xfrm>
          </p:grpSpPr>
          <p:graphicFrame>
            <p:nvGraphicFramePr>
              <p:cNvPr id="4" name="图表 3"/>
              <p:cNvGraphicFramePr/>
              <p:nvPr/>
            </p:nvGraphicFramePr>
            <p:xfrm>
              <a:off x="1296454" y="2918642"/>
              <a:ext cx="2033787" cy="1427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8" name="图表 7"/>
              <p:cNvGraphicFramePr/>
              <p:nvPr/>
            </p:nvGraphicFramePr>
            <p:xfrm>
              <a:off x="3609791" y="2918642"/>
              <a:ext cx="2033787" cy="1427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29" name="TextBox 128"/>
              <p:cNvSpPr txBox="1"/>
              <p:nvPr/>
            </p:nvSpPr>
            <p:spPr>
              <a:xfrm>
                <a:off x="3453615" y="2949631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5</a:t>
                </a:r>
                <a:endParaRPr lang="zh-CN" altLang="en-US" sz="800" b="1" dirty="0"/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3453615" y="3166864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0</a:t>
                </a:r>
                <a:endParaRPr lang="zh-CN" altLang="en-US" sz="800" b="1" dirty="0"/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3453615" y="340789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5</a:t>
                </a:r>
                <a:endParaRPr lang="zh-CN" altLang="en-US" sz="800" b="1" dirty="0"/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3453615" y="3648934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0</a:t>
                </a:r>
                <a:endParaRPr lang="zh-CN" altLang="en-US" sz="800" b="1" dirty="0"/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3453615" y="388997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5</a:t>
                </a:r>
                <a:endParaRPr lang="zh-CN" altLang="en-US" sz="800" b="1" dirty="0"/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1142984" y="325155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2</a:t>
                </a:r>
                <a:endParaRPr lang="zh-CN" altLang="en-US" sz="800" b="1" dirty="0"/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1142984" y="3399096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0</a:t>
                </a:r>
                <a:endParaRPr lang="zh-CN" altLang="en-US" sz="800" b="1" dirty="0"/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>
                <a:off x="1142984" y="354664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8</a:t>
                </a:r>
                <a:endParaRPr lang="zh-CN" altLang="en-US" sz="800" b="1" dirty="0"/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>
                <a:off x="1142984" y="3694184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6</a:t>
                </a:r>
              </a:p>
            </p:txBody>
          </p:sp>
          <p:sp>
            <p:nvSpPr>
              <p:cNvPr id="167" name="TextBox 166"/>
              <p:cNvSpPr txBox="1"/>
              <p:nvPr/>
            </p:nvSpPr>
            <p:spPr>
              <a:xfrm>
                <a:off x="1142984" y="384172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4</a:t>
                </a:r>
                <a:endParaRPr lang="zh-CN" altLang="en-US" sz="800" b="1" dirty="0"/>
              </a:p>
            </p:txBody>
          </p:sp>
          <p:sp>
            <p:nvSpPr>
              <p:cNvPr id="168" name="TextBox 167"/>
              <p:cNvSpPr txBox="1"/>
              <p:nvPr/>
            </p:nvSpPr>
            <p:spPr>
              <a:xfrm>
                <a:off x="1142984" y="310400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4</a:t>
                </a:r>
                <a:endParaRPr lang="zh-CN" altLang="en-US" sz="800" b="1" dirty="0"/>
              </a:p>
            </p:txBody>
          </p:sp>
          <p:sp>
            <p:nvSpPr>
              <p:cNvPr id="169" name="TextBox 168"/>
              <p:cNvSpPr txBox="1"/>
              <p:nvPr/>
            </p:nvSpPr>
            <p:spPr>
              <a:xfrm>
                <a:off x="1142984" y="2956465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6</a:t>
                </a:r>
                <a:endParaRPr lang="zh-CN" altLang="en-US" sz="800" b="1" dirty="0"/>
              </a:p>
            </p:txBody>
          </p:sp>
          <p:sp>
            <p:nvSpPr>
              <p:cNvPr id="177" name="TextBox 176"/>
              <p:cNvSpPr txBox="1"/>
              <p:nvPr/>
            </p:nvSpPr>
            <p:spPr>
              <a:xfrm>
                <a:off x="1142984" y="3989274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2</a:t>
                </a:r>
                <a:endParaRPr lang="zh-CN" altLang="en-US" sz="800" b="1" dirty="0"/>
              </a:p>
            </p:txBody>
          </p:sp>
          <p:sp>
            <p:nvSpPr>
              <p:cNvPr id="185" name="TextBox 184"/>
              <p:cNvSpPr txBox="1"/>
              <p:nvPr/>
            </p:nvSpPr>
            <p:spPr>
              <a:xfrm>
                <a:off x="2124531" y="3025823"/>
                <a:ext cx="105953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i="1" dirty="0" smtClean="0">
                    <a:latin typeface="Arial" pitchFamily="34" charset="0"/>
                    <a:cs typeface="Arial" pitchFamily="34" charset="0"/>
                  </a:rPr>
                  <a:t>GmaPHO1; H3</a:t>
                </a:r>
                <a:endParaRPr lang="zh-CN" altLang="en-US" sz="8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" name="TextBox 188"/>
              <p:cNvSpPr txBox="1"/>
              <p:nvPr/>
            </p:nvSpPr>
            <p:spPr>
              <a:xfrm>
                <a:off x="4437681" y="3025581"/>
                <a:ext cx="9477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i="1" dirty="0" smtClean="0">
                    <a:latin typeface="Arial" pitchFamily="34" charset="0"/>
                    <a:cs typeface="Arial" pitchFamily="34" charset="0"/>
                  </a:rPr>
                  <a:t>GmaPHO1; H5</a:t>
                </a:r>
                <a:endParaRPr lang="zh-CN" altLang="en-US" sz="8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97" name="直接连接符 196"/>
              <p:cNvCxnSpPr/>
              <p:nvPr/>
            </p:nvCxnSpPr>
            <p:spPr>
              <a:xfrm>
                <a:off x="2214554" y="3027526"/>
                <a:ext cx="0" cy="1219195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接连接符 203"/>
              <p:cNvCxnSpPr/>
              <p:nvPr/>
            </p:nvCxnSpPr>
            <p:spPr>
              <a:xfrm>
                <a:off x="4556915" y="3033287"/>
                <a:ext cx="0" cy="1190841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TextBox 80"/>
              <p:cNvSpPr txBox="1"/>
              <p:nvPr/>
            </p:nvSpPr>
            <p:spPr>
              <a:xfrm>
                <a:off x="1071546" y="4096485"/>
                <a:ext cx="43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 smtClean="0"/>
                  <a:t>0</a:t>
                </a:r>
                <a:endParaRPr lang="zh-CN" altLang="en-US" sz="800" b="1" dirty="0"/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3375456" y="4104866"/>
                <a:ext cx="43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 smtClean="0"/>
                  <a:t>0</a:t>
                </a:r>
                <a:endParaRPr lang="zh-CN" altLang="en-US" sz="800" b="1" dirty="0"/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 rot="16200000">
                <a:off x="531831" y="3553544"/>
                <a:ext cx="115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Relative expression</a:t>
                </a:r>
                <a:endParaRPr lang="zh-CN" altLang="en-US" sz="800" b="1" dirty="0"/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 rot="16200000">
                <a:off x="2859578" y="3554898"/>
                <a:ext cx="115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Relative expression</a:t>
                </a:r>
                <a:endParaRPr lang="zh-CN" altLang="en-US" sz="800" b="1" dirty="0"/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971533" y="2913197"/>
                <a:ext cx="2568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b</a:t>
                </a:r>
                <a:endParaRPr lang="zh-CN" altLang="en-US" sz="1000" b="1" dirty="0"/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3286124" y="2913197"/>
                <a:ext cx="2247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f</a:t>
                </a:r>
                <a:endParaRPr lang="zh-CN" altLang="en-US" sz="1000" b="1" dirty="0"/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1739006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8</a:t>
                </a:r>
                <a:endParaRPr lang="zh-CN" altLang="en-US" sz="800" b="1" dirty="0"/>
              </a:p>
            </p:txBody>
          </p:sp>
          <p:sp>
            <p:nvSpPr>
              <p:cNvPr id="229" name="TextBox 228"/>
              <p:cNvSpPr txBox="1"/>
              <p:nvPr/>
            </p:nvSpPr>
            <p:spPr>
              <a:xfrm>
                <a:off x="1908594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2</a:t>
                </a:r>
                <a:endParaRPr lang="zh-CN" altLang="en-US" sz="800" b="1" dirty="0"/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3052760" y="416718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(h)</a:t>
                </a:r>
                <a:endParaRPr lang="zh-CN" altLang="en-US" sz="800" b="1" dirty="0"/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1399830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</a:t>
                </a:r>
                <a:endParaRPr lang="zh-CN" altLang="en-US" sz="800" b="1" dirty="0"/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1569418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</a:t>
                </a:r>
                <a:endParaRPr lang="zh-CN" altLang="en-US" sz="800" b="1" dirty="0"/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2078182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4</a:t>
                </a:r>
                <a:endParaRPr lang="zh-CN" altLang="en-US" sz="800" b="1" dirty="0"/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2586946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2</a:t>
                </a:r>
                <a:endParaRPr lang="zh-CN" altLang="en-US" sz="800" b="1" dirty="0"/>
              </a:p>
            </p:txBody>
          </p:sp>
          <p:sp>
            <p:nvSpPr>
              <p:cNvPr id="235" name="TextBox 234"/>
              <p:cNvSpPr txBox="1"/>
              <p:nvPr/>
            </p:nvSpPr>
            <p:spPr>
              <a:xfrm>
                <a:off x="2756534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6</a:t>
                </a:r>
                <a:endParaRPr lang="zh-CN" altLang="en-US" sz="800" b="1" dirty="0"/>
              </a:p>
            </p:txBody>
          </p:sp>
          <p:sp>
            <p:nvSpPr>
              <p:cNvPr id="236" name="TextBox 235"/>
              <p:cNvSpPr txBox="1"/>
              <p:nvPr/>
            </p:nvSpPr>
            <p:spPr>
              <a:xfrm>
                <a:off x="2247770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6</a:t>
                </a:r>
                <a:endParaRPr lang="zh-CN" altLang="en-US" sz="800" b="1" dirty="0"/>
              </a:p>
            </p:txBody>
          </p:sp>
          <p:sp>
            <p:nvSpPr>
              <p:cNvPr id="237" name="TextBox 236"/>
              <p:cNvSpPr txBox="1"/>
              <p:nvPr/>
            </p:nvSpPr>
            <p:spPr>
              <a:xfrm>
                <a:off x="2417358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8</a:t>
                </a:r>
                <a:endParaRPr lang="zh-CN" altLang="en-US" sz="800" b="1" dirty="0"/>
              </a:p>
            </p:txBody>
          </p:sp>
          <p:sp>
            <p:nvSpPr>
              <p:cNvPr id="238" name="TextBox 237"/>
              <p:cNvSpPr txBox="1"/>
              <p:nvPr/>
            </p:nvSpPr>
            <p:spPr>
              <a:xfrm>
                <a:off x="2926124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8</a:t>
                </a:r>
                <a:endParaRPr lang="zh-CN" altLang="en-US" sz="800" b="1" dirty="0"/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4041228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8</a:t>
                </a:r>
                <a:endParaRPr lang="zh-CN" altLang="en-US" sz="800" b="1" dirty="0"/>
              </a:p>
            </p:txBody>
          </p:sp>
          <p:sp>
            <p:nvSpPr>
              <p:cNvPr id="240" name="TextBox 239"/>
              <p:cNvSpPr txBox="1"/>
              <p:nvPr/>
            </p:nvSpPr>
            <p:spPr>
              <a:xfrm>
                <a:off x="4210816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2</a:t>
                </a:r>
                <a:endParaRPr lang="zh-CN" altLang="en-US" sz="800" b="1" dirty="0"/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>
                <a:off x="5354982" y="416718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(h)</a:t>
                </a:r>
                <a:endParaRPr lang="zh-CN" altLang="en-US" sz="800" b="1" dirty="0"/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3702052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</a:t>
                </a:r>
                <a:endParaRPr lang="zh-CN" altLang="en-US" sz="800" b="1" dirty="0"/>
              </a:p>
            </p:txBody>
          </p:sp>
          <p:sp>
            <p:nvSpPr>
              <p:cNvPr id="243" name="TextBox 242"/>
              <p:cNvSpPr txBox="1"/>
              <p:nvPr/>
            </p:nvSpPr>
            <p:spPr>
              <a:xfrm>
                <a:off x="3871640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</a:t>
                </a:r>
                <a:endParaRPr lang="zh-CN" altLang="en-US" sz="800" b="1" dirty="0"/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4380404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4</a:t>
                </a:r>
                <a:endParaRPr lang="zh-CN" altLang="en-US" sz="800" b="1" dirty="0"/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4889168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2</a:t>
                </a:r>
                <a:endParaRPr lang="zh-CN" altLang="en-US" sz="800" b="1" dirty="0"/>
              </a:p>
            </p:txBody>
          </p:sp>
          <p:sp>
            <p:nvSpPr>
              <p:cNvPr id="246" name="TextBox 245"/>
              <p:cNvSpPr txBox="1"/>
              <p:nvPr/>
            </p:nvSpPr>
            <p:spPr>
              <a:xfrm>
                <a:off x="5058756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6</a:t>
                </a:r>
                <a:endParaRPr lang="zh-CN" altLang="en-US" sz="800" b="1" dirty="0"/>
              </a:p>
            </p:txBody>
          </p:sp>
          <p:sp>
            <p:nvSpPr>
              <p:cNvPr id="247" name="TextBox 246"/>
              <p:cNvSpPr txBox="1"/>
              <p:nvPr/>
            </p:nvSpPr>
            <p:spPr>
              <a:xfrm>
                <a:off x="4549992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6</a:t>
                </a:r>
                <a:endParaRPr lang="zh-CN" altLang="en-US" sz="800" b="1" dirty="0"/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4719580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8</a:t>
                </a:r>
                <a:endParaRPr lang="zh-CN" altLang="en-US" sz="800" b="1" dirty="0"/>
              </a:p>
            </p:txBody>
          </p:sp>
          <p:sp>
            <p:nvSpPr>
              <p:cNvPr id="249" name="TextBox 248"/>
              <p:cNvSpPr txBox="1"/>
              <p:nvPr/>
            </p:nvSpPr>
            <p:spPr>
              <a:xfrm>
                <a:off x="5228346" y="41671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8</a:t>
                </a:r>
                <a:endParaRPr lang="zh-CN" altLang="en-US" sz="800" b="1" dirty="0"/>
              </a:p>
            </p:txBody>
          </p:sp>
        </p:grpSp>
        <p:grpSp>
          <p:nvGrpSpPr>
            <p:cNvPr id="14" name="组合 272"/>
            <p:cNvGrpSpPr/>
            <p:nvPr/>
          </p:nvGrpSpPr>
          <p:grpSpPr>
            <a:xfrm>
              <a:off x="971533" y="1507688"/>
              <a:ext cx="4743483" cy="1465686"/>
              <a:chOff x="971533" y="1507688"/>
              <a:chExt cx="4743483" cy="1465686"/>
            </a:xfrm>
          </p:grpSpPr>
          <p:graphicFrame>
            <p:nvGraphicFramePr>
              <p:cNvPr id="3" name="图表 2"/>
              <p:cNvGraphicFramePr/>
              <p:nvPr/>
            </p:nvGraphicFramePr>
            <p:xfrm>
              <a:off x="1296454" y="1507688"/>
              <a:ext cx="2033787" cy="1427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aphicFrame>
            <p:nvGraphicFramePr>
              <p:cNvPr id="7" name="图表 6"/>
              <p:cNvGraphicFramePr/>
              <p:nvPr/>
            </p:nvGraphicFramePr>
            <p:xfrm>
              <a:off x="3609791" y="1507688"/>
              <a:ext cx="2033787" cy="1427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124" name="TextBox 123"/>
              <p:cNvSpPr txBox="1"/>
              <p:nvPr/>
            </p:nvSpPr>
            <p:spPr>
              <a:xfrm>
                <a:off x="1160914" y="1552986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5</a:t>
                </a:r>
                <a:endParaRPr lang="zh-CN" altLang="en-US" sz="800" b="1" dirty="0"/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1160914" y="1770221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0</a:t>
                </a:r>
                <a:endParaRPr lang="zh-CN" altLang="en-US" sz="800" b="1" dirty="0"/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1160914" y="2011256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5</a:t>
                </a:r>
                <a:endParaRPr lang="zh-CN" altLang="en-US" sz="800" b="1" dirty="0"/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1160914" y="2252291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0</a:t>
                </a:r>
                <a:endParaRPr lang="zh-CN" altLang="en-US" sz="800" b="1" dirty="0"/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1160914" y="2493326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5</a:t>
                </a:r>
                <a:endParaRPr lang="zh-CN" altLang="en-US" sz="800" b="1" dirty="0"/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3454231" y="188124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5</a:t>
                </a:r>
                <a:endParaRPr lang="zh-CN" altLang="en-US" sz="800" b="1" dirty="0"/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3454231" y="204668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.0</a:t>
                </a:r>
                <a:endParaRPr lang="zh-CN" altLang="en-US" sz="800" b="1" dirty="0"/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>
                <a:off x="3454231" y="221211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5</a:t>
                </a:r>
                <a:endParaRPr lang="zh-CN" altLang="en-US" sz="800" b="1" dirty="0"/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3454231" y="2377545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.0</a:t>
                </a:r>
                <a:endParaRPr lang="zh-CN" altLang="en-US" sz="800" b="1" dirty="0"/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3454231" y="254297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0.5</a:t>
                </a:r>
                <a:endParaRPr lang="zh-CN" altLang="en-US" sz="800" b="1" dirty="0"/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>
                <a:off x="3454231" y="171581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.0</a:t>
                </a:r>
                <a:endParaRPr lang="zh-CN" altLang="en-US" sz="800" b="1" dirty="0"/>
              </a:p>
            </p:txBody>
          </p:sp>
          <p:sp>
            <p:nvSpPr>
              <p:cNvPr id="155" name="TextBox 154"/>
              <p:cNvSpPr txBox="1"/>
              <p:nvPr/>
            </p:nvSpPr>
            <p:spPr>
              <a:xfrm>
                <a:off x="3454231" y="1550386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.5</a:t>
                </a:r>
                <a:endParaRPr lang="zh-CN" altLang="en-US" sz="800" b="1" dirty="0"/>
              </a:p>
            </p:txBody>
          </p:sp>
          <p:sp>
            <p:nvSpPr>
              <p:cNvPr id="184" name="TextBox 183"/>
              <p:cNvSpPr txBox="1"/>
              <p:nvPr/>
            </p:nvSpPr>
            <p:spPr>
              <a:xfrm>
                <a:off x="2214553" y="1651186"/>
                <a:ext cx="9881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i="1" dirty="0" smtClean="0">
                    <a:latin typeface="Arial" pitchFamily="34" charset="0"/>
                    <a:cs typeface="Arial" pitchFamily="34" charset="0"/>
                  </a:rPr>
                  <a:t>GmaPHO1; H2</a:t>
                </a:r>
                <a:endParaRPr lang="zh-CN" altLang="en-US" sz="8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8" name="TextBox 187"/>
              <p:cNvSpPr txBox="1"/>
              <p:nvPr/>
            </p:nvSpPr>
            <p:spPr>
              <a:xfrm>
                <a:off x="4437203" y="1653733"/>
                <a:ext cx="116201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i="1" dirty="0" smtClean="0">
                    <a:latin typeface="Arial" pitchFamily="34" charset="0"/>
                    <a:cs typeface="Arial" pitchFamily="34" charset="0"/>
                  </a:rPr>
                  <a:t>GmaPHO1; H1/H4</a:t>
                </a:r>
                <a:endParaRPr lang="zh-CN" altLang="en-US" sz="8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03" name="直接连接符 202"/>
              <p:cNvCxnSpPr/>
              <p:nvPr/>
            </p:nvCxnSpPr>
            <p:spPr>
              <a:xfrm>
                <a:off x="4550742" y="1609700"/>
                <a:ext cx="0" cy="1190841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TextBox 177"/>
              <p:cNvSpPr txBox="1"/>
              <p:nvPr/>
            </p:nvSpPr>
            <p:spPr>
              <a:xfrm rot="16200000">
                <a:off x="531830" y="2206568"/>
                <a:ext cx="115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Relative expression</a:t>
                </a:r>
                <a:endParaRPr lang="zh-CN" altLang="en-US" sz="800" b="1" dirty="0"/>
              </a:p>
            </p:txBody>
          </p:sp>
          <p:cxnSp>
            <p:nvCxnSpPr>
              <p:cNvPr id="193" name="直接连接符 192"/>
              <p:cNvCxnSpPr/>
              <p:nvPr/>
            </p:nvCxnSpPr>
            <p:spPr>
              <a:xfrm>
                <a:off x="2214554" y="1606047"/>
                <a:ext cx="0" cy="1219195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TextBox 79"/>
              <p:cNvSpPr txBox="1"/>
              <p:nvPr/>
            </p:nvSpPr>
            <p:spPr>
              <a:xfrm>
                <a:off x="1071546" y="2688250"/>
                <a:ext cx="43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 smtClean="0"/>
                  <a:t>0</a:t>
                </a:r>
                <a:endParaRPr lang="zh-CN" altLang="en-US" sz="800" b="1" dirty="0"/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3375456" y="2696631"/>
                <a:ext cx="43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 smtClean="0"/>
                  <a:t>0</a:t>
                </a:r>
                <a:endParaRPr lang="zh-CN" altLang="en-US" sz="800" b="1" dirty="0"/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 rot="16200000">
                <a:off x="2859578" y="2206568"/>
                <a:ext cx="115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Relative expression</a:t>
                </a:r>
                <a:endParaRPr lang="zh-CN" altLang="en-US" sz="800" b="1" dirty="0"/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971533" y="1523976"/>
                <a:ext cx="2471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a</a:t>
                </a:r>
                <a:endParaRPr lang="zh-CN" altLang="en-US" sz="1000" b="1" dirty="0"/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3286124" y="1523976"/>
                <a:ext cx="2471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e</a:t>
                </a:r>
                <a:endParaRPr lang="zh-CN" altLang="en-US" sz="1000" b="1" dirty="0"/>
              </a:p>
            </p:txBody>
          </p:sp>
          <p:sp>
            <p:nvSpPr>
              <p:cNvPr id="250" name="TextBox 249"/>
              <p:cNvSpPr txBox="1"/>
              <p:nvPr/>
            </p:nvSpPr>
            <p:spPr>
              <a:xfrm>
                <a:off x="1741850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8</a:t>
                </a:r>
                <a:endParaRPr lang="zh-CN" altLang="en-US" sz="800" b="1" dirty="0"/>
              </a:p>
            </p:txBody>
          </p:sp>
          <p:sp>
            <p:nvSpPr>
              <p:cNvPr id="251" name="TextBox 250"/>
              <p:cNvSpPr txBox="1"/>
              <p:nvPr/>
            </p:nvSpPr>
            <p:spPr>
              <a:xfrm>
                <a:off x="1911438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2</a:t>
                </a:r>
                <a:endParaRPr lang="zh-CN" altLang="en-US" sz="800" b="1" dirty="0"/>
              </a:p>
            </p:txBody>
          </p:sp>
          <p:sp>
            <p:nvSpPr>
              <p:cNvPr id="252" name="TextBox 251"/>
              <p:cNvSpPr txBox="1"/>
              <p:nvPr/>
            </p:nvSpPr>
            <p:spPr>
              <a:xfrm>
                <a:off x="3055604" y="2757930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(h)</a:t>
                </a:r>
                <a:endParaRPr lang="zh-CN" altLang="en-US" sz="800" b="1" dirty="0"/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1402674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</a:t>
                </a:r>
                <a:endParaRPr lang="zh-CN" altLang="en-US" sz="800" b="1" dirty="0"/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1572262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</a:t>
                </a:r>
                <a:endParaRPr lang="zh-CN" altLang="en-US" sz="800" b="1" dirty="0"/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2081026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4</a:t>
                </a:r>
                <a:endParaRPr lang="zh-CN" altLang="en-US" sz="800" b="1" dirty="0"/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2589790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2</a:t>
                </a:r>
                <a:endParaRPr lang="zh-CN" altLang="en-US" sz="800" b="1" dirty="0"/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2759378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6</a:t>
                </a:r>
                <a:endParaRPr lang="zh-CN" altLang="en-US" sz="800" b="1" dirty="0"/>
              </a:p>
            </p:txBody>
          </p:sp>
          <p:sp>
            <p:nvSpPr>
              <p:cNvPr id="258" name="TextBox 257"/>
              <p:cNvSpPr txBox="1"/>
              <p:nvPr/>
            </p:nvSpPr>
            <p:spPr>
              <a:xfrm>
                <a:off x="2250614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6</a:t>
                </a:r>
                <a:endParaRPr lang="zh-CN" altLang="en-US" sz="800" b="1" dirty="0"/>
              </a:p>
            </p:txBody>
          </p:sp>
          <p:sp>
            <p:nvSpPr>
              <p:cNvPr id="259" name="TextBox 258"/>
              <p:cNvSpPr txBox="1"/>
              <p:nvPr/>
            </p:nvSpPr>
            <p:spPr>
              <a:xfrm>
                <a:off x="2420202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8</a:t>
                </a:r>
                <a:endParaRPr lang="zh-CN" altLang="en-US" sz="800" b="1" dirty="0"/>
              </a:p>
            </p:txBody>
          </p:sp>
          <p:sp>
            <p:nvSpPr>
              <p:cNvPr id="260" name="TextBox 259"/>
              <p:cNvSpPr txBox="1"/>
              <p:nvPr/>
            </p:nvSpPr>
            <p:spPr>
              <a:xfrm>
                <a:off x="2928968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8</a:t>
                </a:r>
                <a:endParaRPr lang="zh-CN" altLang="en-US" sz="800" b="1" dirty="0"/>
              </a:p>
            </p:txBody>
          </p:sp>
          <p:sp>
            <p:nvSpPr>
              <p:cNvPr id="261" name="TextBox 260"/>
              <p:cNvSpPr txBox="1"/>
              <p:nvPr/>
            </p:nvSpPr>
            <p:spPr>
              <a:xfrm>
                <a:off x="4044072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8</a:t>
                </a:r>
                <a:endParaRPr lang="zh-CN" altLang="en-US" sz="800" b="1" dirty="0"/>
              </a:p>
            </p:txBody>
          </p:sp>
          <p:sp>
            <p:nvSpPr>
              <p:cNvPr id="262" name="TextBox 261"/>
              <p:cNvSpPr txBox="1"/>
              <p:nvPr/>
            </p:nvSpPr>
            <p:spPr>
              <a:xfrm>
                <a:off x="4213660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12</a:t>
                </a:r>
                <a:endParaRPr lang="zh-CN" altLang="en-US" sz="800" b="1" dirty="0"/>
              </a:p>
            </p:txBody>
          </p:sp>
          <p:sp>
            <p:nvSpPr>
              <p:cNvPr id="263" name="TextBox 262"/>
              <p:cNvSpPr txBox="1"/>
              <p:nvPr/>
            </p:nvSpPr>
            <p:spPr>
              <a:xfrm>
                <a:off x="5357826" y="2757930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(h)</a:t>
                </a:r>
                <a:endParaRPr lang="zh-CN" altLang="en-US" sz="800" b="1" dirty="0"/>
              </a:p>
            </p:txBody>
          </p:sp>
          <p:sp>
            <p:nvSpPr>
              <p:cNvPr id="264" name="TextBox 263"/>
              <p:cNvSpPr txBox="1"/>
              <p:nvPr/>
            </p:nvSpPr>
            <p:spPr>
              <a:xfrm>
                <a:off x="3704896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</a:t>
                </a:r>
                <a:endParaRPr lang="zh-CN" altLang="en-US" sz="800" b="1" dirty="0"/>
              </a:p>
            </p:txBody>
          </p:sp>
          <p:sp>
            <p:nvSpPr>
              <p:cNvPr id="265" name="TextBox 264"/>
              <p:cNvSpPr txBox="1"/>
              <p:nvPr/>
            </p:nvSpPr>
            <p:spPr>
              <a:xfrm>
                <a:off x="3874484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</a:t>
                </a:r>
                <a:endParaRPr lang="zh-CN" altLang="en-US" sz="800" b="1" dirty="0"/>
              </a:p>
            </p:txBody>
          </p:sp>
          <p:sp>
            <p:nvSpPr>
              <p:cNvPr id="266" name="TextBox 265"/>
              <p:cNvSpPr txBox="1"/>
              <p:nvPr/>
            </p:nvSpPr>
            <p:spPr>
              <a:xfrm>
                <a:off x="4383248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4</a:t>
                </a:r>
                <a:endParaRPr lang="zh-CN" altLang="en-US" sz="800" b="1" dirty="0"/>
              </a:p>
            </p:txBody>
          </p:sp>
          <p:sp>
            <p:nvSpPr>
              <p:cNvPr id="267" name="TextBox 266"/>
              <p:cNvSpPr txBox="1"/>
              <p:nvPr/>
            </p:nvSpPr>
            <p:spPr>
              <a:xfrm>
                <a:off x="4892012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2</a:t>
                </a:r>
                <a:endParaRPr lang="zh-CN" altLang="en-US" sz="800" b="1" dirty="0"/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>
                <a:off x="5061600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36</a:t>
                </a:r>
                <a:endParaRPr lang="zh-CN" altLang="en-US" sz="800" b="1" dirty="0"/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>
                <a:off x="4552836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6</a:t>
                </a:r>
                <a:endParaRPr lang="zh-CN" altLang="en-US" sz="800" b="1" dirty="0"/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>
                <a:off x="4722424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28</a:t>
                </a:r>
                <a:endParaRPr lang="zh-CN" altLang="en-US" sz="800" b="1" dirty="0"/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5231190" y="275793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/>
                  <a:t>48</a:t>
                </a:r>
                <a:endParaRPr lang="zh-CN" altLang="en-US" sz="800" b="1" dirty="0"/>
              </a:p>
            </p:txBody>
          </p:sp>
        </p:grpSp>
      </p:grpSp>
      <p:sp>
        <p:nvSpPr>
          <p:cNvPr id="214" name="TextBox 213"/>
          <p:cNvSpPr txBox="1"/>
          <p:nvPr/>
        </p:nvSpPr>
        <p:spPr>
          <a:xfrm>
            <a:off x="1142984" y="7624724"/>
            <a:ext cx="48577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Figure S6. Expression of </a:t>
            </a:r>
            <a:r>
              <a:rPr lang="en-US" sz="1000" b="1" i="1" dirty="0" smtClean="0"/>
              <a:t>GmaPHO1</a:t>
            </a:r>
            <a:r>
              <a:rPr lang="en-US" sz="1000" b="1" dirty="0" smtClean="0"/>
              <a:t> genes under Pi deficient or sufficient treatments.</a:t>
            </a:r>
            <a:endParaRPr lang="zh-CN" altLang="en-US" sz="1000" dirty="0"/>
          </a:p>
        </p:txBody>
      </p:sp>
      <p:sp>
        <p:nvSpPr>
          <p:cNvPr id="192" name="TextBox 191"/>
          <p:cNvSpPr txBox="1"/>
          <p:nvPr/>
        </p:nvSpPr>
        <p:spPr>
          <a:xfrm>
            <a:off x="1546690" y="172727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1544887" y="177512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1722538" y="175131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1890364" y="214468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2420611" y="202017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2941611" y="1892371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3122583" y="181966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2" name="TextBox 271"/>
          <p:cNvSpPr txBox="1"/>
          <p:nvPr/>
        </p:nvSpPr>
        <p:spPr>
          <a:xfrm>
            <a:off x="1723478" y="1787607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3" name="TextBox 272"/>
          <p:cNvSpPr txBox="1"/>
          <p:nvPr/>
        </p:nvSpPr>
        <p:spPr>
          <a:xfrm>
            <a:off x="1890164" y="217732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4" name="TextBox 273"/>
          <p:cNvSpPr txBox="1"/>
          <p:nvPr/>
        </p:nvSpPr>
        <p:spPr>
          <a:xfrm>
            <a:off x="2424795" y="205235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5" name="TextBox 274"/>
          <p:cNvSpPr txBox="1"/>
          <p:nvPr/>
        </p:nvSpPr>
        <p:spPr>
          <a:xfrm>
            <a:off x="2946674" y="192866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6" name="TextBox 275"/>
          <p:cNvSpPr txBox="1"/>
          <p:nvPr/>
        </p:nvSpPr>
        <p:spPr>
          <a:xfrm>
            <a:off x="3129063" y="1868561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/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7" name="TextBox 274"/>
          <p:cNvSpPr txBox="1"/>
          <p:nvPr/>
        </p:nvSpPr>
        <p:spPr>
          <a:xfrm>
            <a:off x="1542506" y="317127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8" name="TextBox 274"/>
          <p:cNvSpPr txBox="1"/>
          <p:nvPr/>
        </p:nvSpPr>
        <p:spPr>
          <a:xfrm>
            <a:off x="1716335" y="3243856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9" name="TextBox 274"/>
          <p:cNvSpPr txBox="1"/>
          <p:nvPr/>
        </p:nvSpPr>
        <p:spPr>
          <a:xfrm>
            <a:off x="2067991" y="328253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0" name="TextBox 274"/>
          <p:cNvSpPr txBox="1"/>
          <p:nvPr/>
        </p:nvSpPr>
        <p:spPr>
          <a:xfrm>
            <a:off x="2600920" y="327776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1" name="TextBox 274"/>
          <p:cNvSpPr txBox="1"/>
          <p:nvPr/>
        </p:nvSpPr>
        <p:spPr>
          <a:xfrm>
            <a:off x="2765225" y="322480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2" name="TextBox 274"/>
          <p:cNvSpPr txBox="1"/>
          <p:nvPr/>
        </p:nvSpPr>
        <p:spPr>
          <a:xfrm>
            <a:off x="2948754" y="322480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3" name="TextBox 274"/>
          <p:cNvSpPr txBox="1"/>
          <p:nvPr/>
        </p:nvSpPr>
        <p:spPr>
          <a:xfrm>
            <a:off x="1542229" y="320448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4" name="TextBox 274"/>
          <p:cNvSpPr txBox="1"/>
          <p:nvPr/>
        </p:nvSpPr>
        <p:spPr>
          <a:xfrm>
            <a:off x="1892745" y="328967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5" name="TextBox 274"/>
          <p:cNvSpPr txBox="1"/>
          <p:nvPr/>
        </p:nvSpPr>
        <p:spPr>
          <a:xfrm>
            <a:off x="2067991" y="331516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6" name="TextBox 274"/>
          <p:cNvSpPr txBox="1"/>
          <p:nvPr/>
        </p:nvSpPr>
        <p:spPr>
          <a:xfrm>
            <a:off x="2600920" y="3317546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7" name="TextBox 274"/>
          <p:cNvSpPr txBox="1"/>
          <p:nvPr/>
        </p:nvSpPr>
        <p:spPr>
          <a:xfrm>
            <a:off x="2949055" y="325744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9" name="TextBox 274"/>
          <p:cNvSpPr txBox="1"/>
          <p:nvPr/>
        </p:nvSpPr>
        <p:spPr>
          <a:xfrm>
            <a:off x="1724919" y="491728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1" name="TextBox 274"/>
          <p:cNvSpPr txBox="1"/>
          <p:nvPr/>
        </p:nvSpPr>
        <p:spPr>
          <a:xfrm>
            <a:off x="2288777" y="4878611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2" name="TextBox 274"/>
          <p:cNvSpPr txBox="1"/>
          <p:nvPr/>
        </p:nvSpPr>
        <p:spPr>
          <a:xfrm>
            <a:off x="2420888" y="493267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3" name="TextBox 274"/>
          <p:cNvSpPr txBox="1"/>
          <p:nvPr/>
        </p:nvSpPr>
        <p:spPr>
          <a:xfrm>
            <a:off x="2600920" y="495300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4" name="TextBox 274"/>
          <p:cNvSpPr txBox="1"/>
          <p:nvPr/>
        </p:nvSpPr>
        <p:spPr>
          <a:xfrm>
            <a:off x="2760463" y="466496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5" name="TextBox 274"/>
          <p:cNvSpPr txBox="1"/>
          <p:nvPr/>
        </p:nvSpPr>
        <p:spPr>
          <a:xfrm>
            <a:off x="3011238" y="4500627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6" name="TextBox 274"/>
          <p:cNvSpPr txBox="1"/>
          <p:nvPr/>
        </p:nvSpPr>
        <p:spPr>
          <a:xfrm>
            <a:off x="3131444" y="493029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7" name="TextBox 274"/>
          <p:cNvSpPr txBox="1"/>
          <p:nvPr/>
        </p:nvSpPr>
        <p:spPr>
          <a:xfrm>
            <a:off x="1542506" y="4957762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8" name="TextBox 274"/>
          <p:cNvSpPr txBox="1"/>
          <p:nvPr/>
        </p:nvSpPr>
        <p:spPr>
          <a:xfrm>
            <a:off x="1724919" y="494823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9" name="TextBox 274"/>
          <p:cNvSpPr txBox="1"/>
          <p:nvPr/>
        </p:nvSpPr>
        <p:spPr>
          <a:xfrm>
            <a:off x="1890364" y="495718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0" name="TextBox 274"/>
          <p:cNvSpPr txBox="1"/>
          <p:nvPr/>
        </p:nvSpPr>
        <p:spPr>
          <a:xfrm>
            <a:off x="2064193" y="496252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1" name="TextBox 274"/>
          <p:cNvSpPr txBox="1"/>
          <p:nvPr/>
        </p:nvSpPr>
        <p:spPr>
          <a:xfrm>
            <a:off x="3001714" y="4530476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2" name="TextBox 274"/>
          <p:cNvSpPr txBox="1"/>
          <p:nvPr/>
        </p:nvSpPr>
        <p:spPr>
          <a:xfrm>
            <a:off x="3133825" y="496014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3" name="TextBox 274"/>
          <p:cNvSpPr txBox="1"/>
          <p:nvPr/>
        </p:nvSpPr>
        <p:spPr>
          <a:xfrm>
            <a:off x="1556792" y="608480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4" name="TextBox 274"/>
          <p:cNvSpPr txBox="1"/>
          <p:nvPr/>
        </p:nvSpPr>
        <p:spPr>
          <a:xfrm>
            <a:off x="1716335" y="623958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5" name="TextBox 274"/>
          <p:cNvSpPr txBox="1"/>
          <p:nvPr/>
        </p:nvSpPr>
        <p:spPr>
          <a:xfrm>
            <a:off x="1890164" y="6088461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6" name="TextBox 274"/>
          <p:cNvSpPr txBox="1"/>
          <p:nvPr/>
        </p:nvSpPr>
        <p:spPr>
          <a:xfrm>
            <a:off x="2063229" y="623848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7" name="TextBox 274"/>
          <p:cNvSpPr txBox="1"/>
          <p:nvPr/>
        </p:nvSpPr>
        <p:spPr>
          <a:xfrm>
            <a:off x="2204864" y="624914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8" name="TextBox 274"/>
          <p:cNvSpPr txBox="1"/>
          <p:nvPr/>
        </p:nvSpPr>
        <p:spPr>
          <a:xfrm>
            <a:off x="2473848" y="6017557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9" name="TextBox 274"/>
          <p:cNvSpPr txBox="1"/>
          <p:nvPr/>
        </p:nvSpPr>
        <p:spPr>
          <a:xfrm>
            <a:off x="2592914" y="617710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0" name="TextBox 274"/>
          <p:cNvSpPr txBox="1"/>
          <p:nvPr/>
        </p:nvSpPr>
        <p:spPr>
          <a:xfrm>
            <a:off x="2764362" y="604374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1" name="TextBox 274"/>
          <p:cNvSpPr txBox="1"/>
          <p:nvPr/>
        </p:nvSpPr>
        <p:spPr>
          <a:xfrm>
            <a:off x="3112119" y="624914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2" name="TextBox 274"/>
          <p:cNvSpPr txBox="1"/>
          <p:nvPr/>
        </p:nvSpPr>
        <p:spPr>
          <a:xfrm>
            <a:off x="1556792" y="6114652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3" name="TextBox 274"/>
          <p:cNvSpPr txBox="1"/>
          <p:nvPr/>
        </p:nvSpPr>
        <p:spPr>
          <a:xfrm>
            <a:off x="1716335" y="6267052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4" name="TextBox 274"/>
          <p:cNvSpPr txBox="1"/>
          <p:nvPr/>
        </p:nvSpPr>
        <p:spPr>
          <a:xfrm>
            <a:off x="1890364" y="611941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5" name="TextBox 274"/>
          <p:cNvSpPr txBox="1"/>
          <p:nvPr/>
        </p:nvSpPr>
        <p:spPr>
          <a:xfrm>
            <a:off x="2060848" y="626343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6" name="TextBox 274"/>
          <p:cNvSpPr txBox="1"/>
          <p:nvPr/>
        </p:nvSpPr>
        <p:spPr>
          <a:xfrm>
            <a:off x="2195340" y="629130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7" name="TextBox 274"/>
          <p:cNvSpPr txBox="1"/>
          <p:nvPr/>
        </p:nvSpPr>
        <p:spPr>
          <a:xfrm>
            <a:off x="2476229" y="604502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8" name="TextBox 274"/>
          <p:cNvSpPr txBox="1"/>
          <p:nvPr/>
        </p:nvSpPr>
        <p:spPr>
          <a:xfrm>
            <a:off x="3109738" y="628416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9" name="TextBox 274"/>
          <p:cNvSpPr txBox="1"/>
          <p:nvPr/>
        </p:nvSpPr>
        <p:spPr>
          <a:xfrm>
            <a:off x="3858667" y="224218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0" name="TextBox 274"/>
          <p:cNvSpPr txBox="1"/>
          <p:nvPr/>
        </p:nvSpPr>
        <p:spPr>
          <a:xfrm>
            <a:off x="4377310" y="207268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1" name="TextBox 274"/>
          <p:cNvSpPr txBox="1"/>
          <p:nvPr/>
        </p:nvSpPr>
        <p:spPr>
          <a:xfrm>
            <a:off x="4725144" y="2360712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2" name="TextBox 274"/>
          <p:cNvSpPr txBox="1"/>
          <p:nvPr/>
        </p:nvSpPr>
        <p:spPr>
          <a:xfrm>
            <a:off x="4905176" y="2216696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3" name="TextBox 274"/>
          <p:cNvSpPr txBox="1"/>
          <p:nvPr/>
        </p:nvSpPr>
        <p:spPr>
          <a:xfrm>
            <a:off x="5085184" y="1836331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4" name="TextBox 274"/>
          <p:cNvSpPr txBox="1"/>
          <p:nvPr/>
        </p:nvSpPr>
        <p:spPr>
          <a:xfrm>
            <a:off x="5423518" y="212436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5" name="TextBox 274"/>
          <p:cNvSpPr txBox="1"/>
          <p:nvPr/>
        </p:nvSpPr>
        <p:spPr>
          <a:xfrm>
            <a:off x="5267874" y="2249331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6" name="TextBox 274"/>
          <p:cNvSpPr txBox="1"/>
          <p:nvPr/>
        </p:nvSpPr>
        <p:spPr>
          <a:xfrm>
            <a:off x="3861048" y="228870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7" name="TextBox 274"/>
          <p:cNvSpPr txBox="1"/>
          <p:nvPr/>
        </p:nvSpPr>
        <p:spPr>
          <a:xfrm>
            <a:off x="4041080" y="2360712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8" name="TextBox 274"/>
          <p:cNvSpPr txBox="1"/>
          <p:nvPr/>
        </p:nvSpPr>
        <p:spPr>
          <a:xfrm>
            <a:off x="4194620" y="241239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9" name="TextBox 274"/>
          <p:cNvSpPr txBox="1"/>
          <p:nvPr/>
        </p:nvSpPr>
        <p:spPr>
          <a:xfrm>
            <a:off x="4379691" y="2107696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0" name="TextBox 274"/>
          <p:cNvSpPr txBox="1"/>
          <p:nvPr/>
        </p:nvSpPr>
        <p:spPr>
          <a:xfrm>
            <a:off x="4532091" y="2340387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1" name="TextBox 274"/>
          <p:cNvSpPr txBox="1"/>
          <p:nvPr/>
        </p:nvSpPr>
        <p:spPr>
          <a:xfrm>
            <a:off x="4905176" y="225409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2" name="TextBox 274"/>
          <p:cNvSpPr txBox="1"/>
          <p:nvPr/>
        </p:nvSpPr>
        <p:spPr>
          <a:xfrm>
            <a:off x="5081386" y="187332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3" name="TextBox 274"/>
          <p:cNvSpPr txBox="1"/>
          <p:nvPr/>
        </p:nvSpPr>
        <p:spPr>
          <a:xfrm>
            <a:off x="5272359" y="228870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4" name="TextBox 274"/>
          <p:cNvSpPr txBox="1"/>
          <p:nvPr/>
        </p:nvSpPr>
        <p:spPr>
          <a:xfrm>
            <a:off x="5424759" y="215659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5" name="TextBox 274"/>
          <p:cNvSpPr txBox="1"/>
          <p:nvPr/>
        </p:nvSpPr>
        <p:spPr>
          <a:xfrm>
            <a:off x="3861048" y="3276491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6" name="TextBox 274"/>
          <p:cNvSpPr txBox="1"/>
          <p:nvPr/>
        </p:nvSpPr>
        <p:spPr>
          <a:xfrm>
            <a:off x="4024413" y="354079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7" name="TextBox 274"/>
          <p:cNvSpPr txBox="1"/>
          <p:nvPr/>
        </p:nvSpPr>
        <p:spPr>
          <a:xfrm>
            <a:off x="4205385" y="358484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8" name="TextBox 274"/>
          <p:cNvSpPr txBox="1"/>
          <p:nvPr/>
        </p:nvSpPr>
        <p:spPr>
          <a:xfrm>
            <a:off x="4379214" y="3250999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9" name="TextBox 274"/>
          <p:cNvSpPr txBox="1"/>
          <p:nvPr/>
        </p:nvSpPr>
        <p:spPr>
          <a:xfrm>
            <a:off x="4531614" y="356452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0" name="TextBox 274"/>
          <p:cNvSpPr txBox="1"/>
          <p:nvPr/>
        </p:nvSpPr>
        <p:spPr>
          <a:xfrm>
            <a:off x="4725144" y="358484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1" name="TextBox 274"/>
          <p:cNvSpPr txBox="1"/>
          <p:nvPr/>
        </p:nvSpPr>
        <p:spPr>
          <a:xfrm>
            <a:off x="4896592" y="336882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2" name="TextBox 274"/>
          <p:cNvSpPr txBox="1"/>
          <p:nvPr/>
        </p:nvSpPr>
        <p:spPr>
          <a:xfrm>
            <a:off x="5085184" y="336882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3" name="TextBox 274"/>
          <p:cNvSpPr txBox="1"/>
          <p:nvPr/>
        </p:nvSpPr>
        <p:spPr>
          <a:xfrm>
            <a:off x="5344066" y="315994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4" name="TextBox 274"/>
          <p:cNvSpPr txBox="1"/>
          <p:nvPr/>
        </p:nvSpPr>
        <p:spPr>
          <a:xfrm>
            <a:off x="4206802" y="362224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5" name="TextBox 274"/>
          <p:cNvSpPr txBox="1"/>
          <p:nvPr/>
        </p:nvSpPr>
        <p:spPr>
          <a:xfrm>
            <a:off x="4379691" y="3276491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6" name="TextBox 274"/>
          <p:cNvSpPr txBox="1"/>
          <p:nvPr/>
        </p:nvSpPr>
        <p:spPr>
          <a:xfrm>
            <a:off x="4532091" y="359843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7" name="TextBox 274"/>
          <p:cNvSpPr txBox="1"/>
          <p:nvPr/>
        </p:nvSpPr>
        <p:spPr>
          <a:xfrm>
            <a:off x="4725144" y="361986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8" name="TextBox 274"/>
          <p:cNvSpPr txBox="1"/>
          <p:nvPr/>
        </p:nvSpPr>
        <p:spPr>
          <a:xfrm>
            <a:off x="4898033" y="340384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9" name="TextBox 274"/>
          <p:cNvSpPr txBox="1"/>
          <p:nvPr/>
        </p:nvSpPr>
        <p:spPr>
          <a:xfrm>
            <a:off x="5081386" y="3405117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0" name="TextBox 274"/>
          <p:cNvSpPr txBox="1"/>
          <p:nvPr/>
        </p:nvSpPr>
        <p:spPr>
          <a:xfrm>
            <a:off x="5344367" y="319734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1" name="TextBox 274"/>
          <p:cNvSpPr txBox="1"/>
          <p:nvPr/>
        </p:nvSpPr>
        <p:spPr>
          <a:xfrm>
            <a:off x="3861048" y="4788659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2" name="TextBox 274"/>
          <p:cNvSpPr txBox="1"/>
          <p:nvPr/>
        </p:nvSpPr>
        <p:spPr>
          <a:xfrm>
            <a:off x="4013448" y="495300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3" name="TextBox 274"/>
          <p:cNvSpPr txBox="1"/>
          <p:nvPr/>
        </p:nvSpPr>
        <p:spPr>
          <a:xfrm>
            <a:off x="4221088" y="495300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4" name="TextBox 274"/>
          <p:cNvSpPr txBox="1"/>
          <p:nvPr/>
        </p:nvSpPr>
        <p:spPr>
          <a:xfrm>
            <a:off x="4535612" y="488337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5" name="TextBox 274"/>
          <p:cNvSpPr txBox="1"/>
          <p:nvPr/>
        </p:nvSpPr>
        <p:spPr>
          <a:xfrm>
            <a:off x="4725144" y="495300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6" name="TextBox 274"/>
          <p:cNvSpPr txBox="1"/>
          <p:nvPr/>
        </p:nvSpPr>
        <p:spPr>
          <a:xfrm>
            <a:off x="5085184" y="4736976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7" name="TextBox 274"/>
          <p:cNvSpPr txBox="1"/>
          <p:nvPr/>
        </p:nvSpPr>
        <p:spPr>
          <a:xfrm>
            <a:off x="5351510" y="467321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8" name="TextBox 274"/>
          <p:cNvSpPr txBox="1"/>
          <p:nvPr/>
        </p:nvSpPr>
        <p:spPr>
          <a:xfrm>
            <a:off x="5445224" y="495300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9" name="TextBox 274"/>
          <p:cNvSpPr txBox="1"/>
          <p:nvPr/>
        </p:nvSpPr>
        <p:spPr>
          <a:xfrm>
            <a:off x="3861048" y="4813746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0" name="TextBox 274"/>
          <p:cNvSpPr txBox="1"/>
          <p:nvPr/>
        </p:nvSpPr>
        <p:spPr>
          <a:xfrm>
            <a:off x="4013448" y="498281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1" name="TextBox 274"/>
          <p:cNvSpPr txBox="1"/>
          <p:nvPr/>
        </p:nvSpPr>
        <p:spPr>
          <a:xfrm>
            <a:off x="4221088" y="498563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2" name="TextBox 274"/>
          <p:cNvSpPr txBox="1"/>
          <p:nvPr/>
        </p:nvSpPr>
        <p:spPr>
          <a:xfrm>
            <a:off x="4378250" y="473221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3" name="TextBox 274"/>
          <p:cNvSpPr txBox="1"/>
          <p:nvPr/>
        </p:nvSpPr>
        <p:spPr>
          <a:xfrm>
            <a:off x="4725144" y="4990397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4" name="TextBox 274"/>
          <p:cNvSpPr txBox="1"/>
          <p:nvPr/>
        </p:nvSpPr>
        <p:spPr>
          <a:xfrm>
            <a:off x="4901354" y="4880992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5" name="TextBox 274"/>
          <p:cNvSpPr txBox="1"/>
          <p:nvPr/>
        </p:nvSpPr>
        <p:spPr>
          <a:xfrm>
            <a:off x="5084707" y="4773269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6" name="TextBox 274"/>
          <p:cNvSpPr txBox="1"/>
          <p:nvPr/>
        </p:nvSpPr>
        <p:spPr>
          <a:xfrm>
            <a:off x="5351510" y="471735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7" name="TextBox 274"/>
          <p:cNvSpPr txBox="1"/>
          <p:nvPr/>
        </p:nvSpPr>
        <p:spPr>
          <a:xfrm>
            <a:off x="5445224" y="498395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8" name="TextBox 274"/>
          <p:cNvSpPr txBox="1"/>
          <p:nvPr/>
        </p:nvSpPr>
        <p:spPr>
          <a:xfrm>
            <a:off x="3861048" y="6084803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69" name="TextBox 274"/>
          <p:cNvSpPr txBox="1"/>
          <p:nvPr/>
        </p:nvSpPr>
        <p:spPr>
          <a:xfrm>
            <a:off x="4041080" y="637283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70" name="TextBox 274"/>
          <p:cNvSpPr txBox="1"/>
          <p:nvPr/>
        </p:nvSpPr>
        <p:spPr>
          <a:xfrm>
            <a:off x="4492176" y="6390779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71" name="TextBox 274"/>
          <p:cNvSpPr txBox="1"/>
          <p:nvPr/>
        </p:nvSpPr>
        <p:spPr>
          <a:xfrm>
            <a:off x="4725144" y="6177136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72" name="TextBox 274"/>
          <p:cNvSpPr txBox="1"/>
          <p:nvPr/>
        </p:nvSpPr>
        <p:spPr>
          <a:xfrm>
            <a:off x="5085184" y="6049088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73" name="TextBox 274"/>
          <p:cNvSpPr txBox="1"/>
          <p:nvPr/>
        </p:nvSpPr>
        <p:spPr>
          <a:xfrm>
            <a:off x="3861048" y="612179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4" name="TextBox 274"/>
          <p:cNvSpPr txBox="1"/>
          <p:nvPr/>
        </p:nvSpPr>
        <p:spPr>
          <a:xfrm>
            <a:off x="4206802" y="6372835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5" name="TextBox 274"/>
          <p:cNvSpPr txBox="1"/>
          <p:nvPr/>
        </p:nvSpPr>
        <p:spPr>
          <a:xfrm>
            <a:off x="4381771" y="6342581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6" name="TextBox 274"/>
          <p:cNvSpPr txBox="1"/>
          <p:nvPr/>
        </p:nvSpPr>
        <p:spPr>
          <a:xfrm>
            <a:off x="4489795" y="642341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7" name="TextBox 274"/>
          <p:cNvSpPr txBox="1"/>
          <p:nvPr/>
        </p:nvSpPr>
        <p:spPr>
          <a:xfrm>
            <a:off x="4725144" y="6216914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8" name="TextBox 274"/>
          <p:cNvSpPr txBox="1"/>
          <p:nvPr/>
        </p:nvSpPr>
        <p:spPr>
          <a:xfrm>
            <a:off x="4903735" y="6030739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9" name="TextBox 274"/>
          <p:cNvSpPr txBox="1"/>
          <p:nvPr/>
        </p:nvSpPr>
        <p:spPr>
          <a:xfrm>
            <a:off x="5085184" y="6077660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0" name="TextBox 274"/>
          <p:cNvSpPr txBox="1"/>
          <p:nvPr/>
        </p:nvSpPr>
        <p:spPr>
          <a:xfrm>
            <a:off x="5251870" y="6177136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1" name="TextBox 274"/>
          <p:cNvSpPr txBox="1"/>
          <p:nvPr/>
        </p:nvSpPr>
        <p:spPr>
          <a:xfrm>
            <a:off x="2764261" y="4696499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2" name="TextBox 274"/>
          <p:cNvSpPr txBox="1"/>
          <p:nvPr/>
        </p:nvSpPr>
        <p:spPr>
          <a:xfrm>
            <a:off x="2594054" y="6203327"/>
            <a:ext cx="108000" cy="92333"/>
          </a:xfrm>
          <a:prstGeom prst="rect">
            <a:avLst/>
          </a:prstGeom>
          <a:noFill/>
        </p:spPr>
        <p:txBody>
          <a:bodyPr wrap="square" lIns="0" tIns="0" rIns="0" bIns="0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</TotalTime>
  <Words>334</Words>
  <Application>Microsoft Office PowerPoint</Application>
  <PresentationFormat>A4 纸张(210x297 毫米)</PresentationFormat>
  <Paragraphs>28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zhongkeyua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elingli</dc:creator>
  <cp:lastModifiedBy>unknown</cp:lastModifiedBy>
  <cp:revision>29</cp:revision>
  <dcterms:created xsi:type="dcterms:W3CDTF">2013-03-30T11:00:52Z</dcterms:created>
  <dcterms:modified xsi:type="dcterms:W3CDTF">2013-05-21T07:09:52Z</dcterms:modified>
</cp:coreProperties>
</file>